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emf" ContentType="image/x-emf"/>
  <Default Extension="rels" ContentType="application/vnd.openxmlformats-package.relationships+xml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87" r:id="rId2"/>
    <p:sldId id="270" r:id="rId3"/>
    <p:sldId id="271" r:id="rId4"/>
    <p:sldId id="275" r:id="rId5"/>
    <p:sldId id="283" r:id="rId6"/>
    <p:sldId id="282" r:id="rId7"/>
    <p:sldId id="286" r:id="rId8"/>
    <p:sldId id="288" r:id="rId9"/>
    <p:sldId id="290" r:id="rId10"/>
    <p:sldId id="291" r:id="rId11"/>
  </p:sldIdLst>
  <p:sldSz cx="18003838" cy="13679488"/>
  <p:notesSz cx="6858000" cy="9144000"/>
  <p:defaultTextStyle>
    <a:defPPr>
      <a:defRPr lang="en-US"/>
    </a:defPPr>
    <a:lvl1pPr marL="0" algn="l" defTabSz="1809332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1pPr>
    <a:lvl2pPr marL="904664" algn="l" defTabSz="1809332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2pPr>
    <a:lvl3pPr marL="1809332" algn="l" defTabSz="1809332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3pPr>
    <a:lvl4pPr marL="2713999" algn="l" defTabSz="1809332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4pPr>
    <a:lvl5pPr marL="3618663" algn="l" defTabSz="1809332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5pPr>
    <a:lvl6pPr marL="4523327" algn="l" defTabSz="1809332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6pPr>
    <a:lvl7pPr marL="5427993" algn="l" defTabSz="1809332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7pPr>
    <a:lvl8pPr marL="6332659" algn="l" defTabSz="1809332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8pPr>
    <a:lvl9pPr marL="7237323" algn="l" defTabSz="1809332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80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244" autoAdjust="0"/>
    <p:restoredTop sz="95890" autoAdjust="0"/>
  </p:normalViewPr>
  <p:slideViewPr>
    <p:cSldViewPr>
      <p:cViewPr>
        <p:scale>
          <a:sx n="45" d="100"/>
          <a:sy n="45" d="100"/>
        </p:scale>
        <p:origin x="-1488" y="-208"/>
      </p:cViewPr>
      <p:guideLst>
        <p:guide orient="horz" pos="1630"/>
        <p:guide pos="630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notesMaster" Target="notesMasters/notesMaster1.xml"/><Relationship Id="rId13" Type="http://schemas.openxmlformats.org/officeDocument/2006/relationships/printerSettings" Target="printerSettings/printerSettings1.bin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578376DD-277D-7C48-81DC-653553CEFEB4}" type="doc">
      <dgm:prSet loTypeId="urn:microsoft.com/office/officeart/2005/8/layout/chevron2" loCatId="relationship" qsTypeId="urn:microsoft.com/office/officeart/2005/8/quickstyle/simple4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F43E674B-A107-DF4B-9EFD-D823CAD502BA}">
      <dgm:prSet phldrT="[Text]" custT="1"/>
      <dgm:spPr/>
      <dgm:t>
        <a:bodyPr/>
        <a:lstStyle/>
        <a:p>
          <a:r>
            <a:rPr lang="en-US" sz="2600" dirty="0" smtClean="0">
              <a:solidFill>
                <a:srgbClr val="FFFFFF"/>
              </a:solidFill>
            </a:rPr>
            <a:t>Exploratory analysis</a:t>
          </a:r>
        </a:p>
      </dgm:t>
    </dgm:pt>
    <dgm:pt modelId="{02A50E48-ED62-CB41-826E-73BAAE3879BC}" type="parTrans" cxnId="{13420266-D42C-AE43-9F26-60A521322A82}">
      <dgm:prSet/>
      <dgm:spPr/>
      <dgm:t>
        <a:bodyPr/>
        <a:lstStyle/>
        <a:p>
          <a:endParaRPr lang="en-US"/>
        </a:p>
      </dgm:t>
    </dgm:pt>
    <dgm:pt modelId="{48321DB6-0BCE-4141-A9DF-022D459C26D7}" type="sibTrans" cxnId="{13420266-D42C-AE43-9F26-60A521322A82}">
      <dgm:prSet/>
      <dgm:spPr/>
      <dgm:t>
        <a:bodyPr/>
        <a:lstStyle/>
        <a:p>
          <a:endParaRPr lang="en-US"/>
        </a:p>
      </dgm:t>
    </dgm:pt>
    <dgm:pt modelId="{2B7F9C90-7FB3-4940-B870-541619C49125}">
      <dgm:prSet phldrT="[Text]" custT="1"/>
      <dgm:spPr/>
      <dgm:t>
        <a:bodyPr/>
        <a:lstStyle/>
        <a:p>
          <a:r>
            <a:rPr lang="en-US" sz="2400" dirty="0" smtClean="0"/>
            <a:t>Principal component analysis</a:t>
          </a:r>
          <a:endParaRPr lang="en-US" sz="2400" dirty="0"/>
        </a:p>
      </dgm:t>
    </dgm:pt>
    <dgm:pt modelId="{4249BC22-206B-F946-BD48-E386FCFFC8E9}" type="parTrans" cxnId="{160D2678-EC36-7F46-9131-A475D3D651E0}">
      <dgm:prSet/>
      <dgm:spPr/>
      <dgm:t>
        <a:bodyPr/>
        <a:lstStyle/>
        <a:p>
          <a:endParaRPr lang="en-US"/>
        </a:p>
      </dgm:t>
    </dgm:pt>
    <dgm:pt modelId="{5ED81182-8601-6E44-AFA0-BD61D82354A3}" type="sibTrans" cxnId="{160D2678-EC36-7F46-9131-A475D3D651E0}">
      <dgm:prSet/>
      <dgm:spPr/>
      <dgm:t>
        <a:bodyPr/>
        <a:lstStyle/>
        <a:p>
          <a:endParaRPr lang="en-US"/>
        </a:p>
      </dgm:t>
    </dgm:pt>
    <dgm:pt modelId="{062668BE-90E9-8D4E-93B8-F20A2DC30EAC}">
      <dgm:prSet phldrT="[Text]" custT="1"/>
      <dgm:spPr/>
      <dgm:t>
        <a:bodyPr/>
        <a:lstStyle/>
        <a:p>
          <a:r>
            <a:rPr lang="en-US" sz="2600" dirty="0" smtClean="0">
              <a:solidFill>
                <a:schemeClr val="bg1"/>
              </a:solidFill>
            </a:rPr>
            <a:t>Pre-processing of raw data</a:t>
          </a:r>
        </a:p>
      </dgm:t>
    </dgm:pt>
    <dgm:pt modelId="{C573A246-487D-3142-B4D4-A30C2D5DB496}" type="parTrans" cxnId="{7ACC1B62-684F-1D47-820C-C14BD1025558}">
      <dgm:prSet/>
      <dgm:spPr/>
      <dgm:t>
        <a:bodyPr/>
        <a:lstStyle/>
        <a:p>
          <a:endParaRPr lang="en-US"/>
        </a:p>
      </dgm:t>
    </dgm:pt>
    <dgm:pt modelId="{98D89EF4-E7BD-1440-91FF-47A42BFE2036}" type="sibTrans" cxnId="{7ACC1B62-684F-1D47-820C-C14BD1025558}">
      <dgm:prSet/>
      <dgm:spPr/>
      <dgm:t>
        <a:bodyPr/>
        <a:lstStyle/>
        <a:p>
          <a:endParaRPr lang="en-US"/>
        </a:p>
      </dgm:t>
    </dgm:pt>
    <dgm:pt modelId="{E49B05FA-9620-CA4B-967A-717D7A2D8EE6}">
      <dgm:prSet phldrT="[Text]" custT="1"/>
      <dgm:spPr/>
      <dgm:t>
        <a:bodyPr/>
        <a:lstStyle/>
        <a:p>
          <a:r>
            <a:rPr lang="en-US" sz="2400" dirty="0" smtClean="0"/>
            <a:t>Removal of cross-reactive probes</a:t>
          </a:r>
          <a:endParaRPr lang="en-US" sz="2400" dirty="0"/>
        </a:p>
      </dgm:t>
    </dgm:pt>
    <dgm:pt modelId="{398C4A83-611C-134E-B02D-30C608FABFF7}" type="parTrans" cxnId="{E9DEE8B7-DCD5-4848-9FB3-9F840AA594F5}">
      <dgm:prSet/>
      <dgm:spPr/>
      <dgm:t>
        <a:bodyPr/>
        <a:lstStyle/>
        <a:p>
          <a:endParaRPr lang="en-US"/>
        </a:p>
      </dgm:t>
    </dgm:pt>
    <dgm:pt modelId="{D3306E14-A65E-AC4E-B239-759BB48D862F}" type="sibTrans" cxnId="{E9DEE8B7-DCD5-4848-9FB3-9F840AA594F5}">
      <dgm:prSet/>
      <dgm:spPr/>
      <dgm:t>
        <a:bodyPr/>
        <a:lstStyle/>
        <a:p>
          <a:endParaRPr lang="en-US"/>
        </a:p>
      </dgm:t>
    </dgm:pt>
    <dgm:pt modelId="{CDBE67AF-7735-0F4D-8329-981B5B39E64C}">
      <dgm:prSet phldrT="[Text]" custT="1"/>
      <dgm:spPr/>
      <dgm:t>
        <a:bodyPr/>
        <a:lstStyle/>
        <a:p>
          <a:r>
            <a:rPr lang="en-US" sz="2400" dirty="0" smtClean="0"/>
            <a:t>Removal of SNPs, </a:t>
          </a:r>
          <a:r>
            <a:rPr lang="en-US" sz="2400" dirty="0" err="1" smtClean="0"/>
            <a:t>chr</a:t>
          </a:r>
          <a:r>
            <a:rPr lang="en-US" sz="2400" dirty="0" smtClean="0"/>
            <a:t> X and Y</a:t>
          </a:r>
          <a:endParaRPr lang="en-US" sz="2400" dirty="0"/>
        </a:p>
      </dgm:t>
    </dgm:pt>
    <dgm:pt modelId="{F9756A54-3BDA-6B47-95FA-62491902484F}" type="parTrans" cxnId="{4CD5F352-8D6A-E04F-834E-FF96C96980E4}">
      <dgm:prSet/>
      <dgm:spPr/>
      <dgm:t>
        <a:bodyPr/>
        <a:lstStyle/>
        <a:p>
          <a:endParaRPr lang="en-US"/>
        </a:p>
      </dgm:t>
    </dgm:pt>
    <dgm:pt modelId="{A8DEB94C-9A7D-B549-888C-D1AB2EB4271D}" type="sibTrans" cxnId="{4CD5F352-8D6A-E04F-834E-FF96C96980E4}">
      <dgm:prSet/>
      <dgm:spPr/>
      <dgm:t>
        <a:bodyPr/>
        <a:lstStyle/>
        <a:p>
          <a:endParaRPr lang="en-US"/>
        </a:p>
      </dgm:t>
    </dgm:pt>
    <dgm:pt modelId="{85CC7AD2-0447-D949-9A05-F4CA55ABFDC4}">
      <dgm:prSet phldrT="[Text]" custT="1"/>
      <dgm:spPr/>
      <dgm:t>
        <a:bodyPr/>
        <a:lstStyle/>
        <a:p>
          <a:r>
            <a:rPr lang="en-US" sz="2400" dirty="0" smtClean="0">
              <a:solidFill>
                <a:srgbClr val="000000"/>
              </a:solidFill>
            </a:rPr>
            <a:t>Normalization, batch correction </a:t>
          </a:r>
          <a:endParaRPr lang="en-US" sz="2400" dirty="0"/>
        </a:p>
      </dgm:t>
    </dgm:pt>
    <dgm:pt modelId="{1B841000-AEDC-8141-B41E-639F9093B8F2}" type="parTrans" cxnId="{76CA5694-4CDA-AB43-AF9D-8E7F6E9A675C}">
      <dgm:prSet/>
      <dgm:spPr/>
      <dgm:t>
        <a:bodyPr/>
        <a:lstStyle/>
        <a:p>
          <a:endParaRPr lang="en-US"/>
        </a:p>
      </dgm:t>
    </dgm:pt>
    <dgm:pt modelId="{37FAC019-F7C4-154B-9BAC-E412BF2AE9D0}" type="sibTrans" cxnId="{76CA5694-4CDA-AB43-AF9D-8E7F6E9A675C}">
      <dgm:prSet/>
      <dgm:spPr/>
      <dgm:t>
        <a:bodyPr/>
        <a:lstStyle/>
        <a:p>
          <a:endParaRPr lang="en-US"/>
        </a:p>
      </dgm:t>
    </dgm:pt>
    <dgm:pt modelId="{158043F8-675D-994E-A478-A0626B1ACDC6}">
      <dgm:prSet phldrT="[Text]" custT="1"/>
      <dgm:spPr/>
      <dgm:t>
        <a:bodyPr/>
        <a:lstStyle/>
        <a:p>
          <a:r>
            <a:rPr lang="en-US" sz="2400" dirty="0" smtClean="0">
              <a:solidFill>
                <a:srgbClr val="000000"/>
              </a:solidFill>
            </a:rPr>
            <a:t>Filter by variance</a:t>
          </a:r>
          <a:endParaRPr lang="en-US" sz="2400" dirty="0"/>
        </a:p>
      </dgm:t>
    </dgm:pt>
    <dgm:pt modelId="{83081E97-945D-8C47-9DCB-2CBB9C728BD7}" type="parTrans" cxnId="{D461C295-5F24-B14B-BDDC-16876F1728F9}">
      <dgm:prSet/>
      <dgm:spPr/>
      <dgm:t>
        <a:bodyPr/>
        <a:lstStyle/>
        <a:p>
          <a:endParaRPr lang="en-US"/>
        </a:p>
      </dgm:t>
    </dgm:pt>
    <dgm:pt modelId="{CAAA37AD-2BD2-BA48-9DCD-AE70152BFFFF}" type="sibTrans" cxnId="{D461C295-5F24-B14B-BDDC-16876F1728F9}">
      <dgm:prSet/>
      <dgm:spPr/>
      <dgm:t>
        <a:bodyPr/>
        <a:lstStyle/>
        <a:p>
          <a:endParaRPr lang="en-US"/>
        </a:p>
      </dgm:t>
    </dgm:pt>
    <dgm:pt modelId="{0E9DB17E-01B7-5246-A0D6-3F9EBB299968}">
      <dgm:prSet phldrT="[Text]" custT="1"/>
      <dgm:spPr/>
      <dgm:t>
        <a:bodyPr/>
        <a:lstStyle/>
        <a:p>
          <a:r>
            <a:rPr lang="en-US" sz="2400" dirty="0" smtClean="0"/>
            <a:t>Hierarchical clustering</a:t>
          </a:r>
          <a:endParaRPr lang="en-US" sz="2400" dirty="0"/>
        </a:p>
      </dgm:t>
    </dgm:pt>
    <dgm:pt modelId="{577745E3-E9C9-E949-A4ED-6F1339F1CA99}" type="parTrans" cxnId="{AB59295B-965E-3D4C-AC17-F7C02CB187C1}">
      <dgm:prSet/>
      <dgm:spPr/>
      <dgm:t>
        <a:bodyPr/>
        <a:lstStyle/>
        <a:p>
          <a:endParaRPr lang="en-US"/>
        </a:p>
      </dgm:t>
    </dgm:pt>
    <dgm:pt modelId="{94ACAD15-002C-8545-A4A6-DEF749A287CF}" type="sibTrans" cxnId="{AB59295B-965E-3D4C-AC17-F7C02CB187C1}">
      <dgm:prSet/>
      <dgm:spPr/>
      <dgm:t>
        <a:bodyPr/>
        <a:lstStyle/>
        <a:p>
          <a:endParaRPr lang="en-US"/>
        </a:p>
      </dgm:t>
    </dgm:pt>
    <dgm:pt modelId="{A500AEA8-C9EC-3744-82EA-10B67A5A945F}">
      <dgm:prSet phldrT="[Text]" custT="1"/>
      <dgm:spPr/>
      <dgm:t>
        <a:bodyPr/>
        <a:lstStyle/>
        <a:p>
          <a:r>
            <a:rPr lang="en-US" sz="2400" dirty="0" smtClean="0"/>
            <a:t>Exploratory data analysis</a:t>
          </a:r>
          <a:endParaRPr lang="en-US" sz="2400" dirty="0"/>
        </a:p>
      </dgm:t>
    </dgm:pt>
    <dgm:pt modelId="{A856017C-9E5B-074D-AEB8-DCCC1E53D122}" type="parTrans" cxnId="{5EAA7FCD-71BF-A34A-B9C9-E202738A4689}">
      <dgm:prSet/>
      <dgm:spPr/>
      <dgm:t>
        <a:bodyPr/>
        <a:lstStyle/>
        <a:p>
          <a:endParaRPr lang="en-US"/>
        </a:p>
      </dgm:t>
    </dgm:pt>
    <dgm:pt modelId="{1C8A41ED-E785-9B41-9915-A72701E24B6D}" type="sibTrans" cxnId="{5EAA7FCD-71BF-A34A-B9C9-E202738A4689}">
      <dgm:prSet/>
      <dgm:spPr/>
      <dgm:t>
        <a:bodyPr/>
        <a:lstStyle/>
        <a:p>
          <a:endParaRPr lang="en-US"/>
        </a:p>
      </dgm:t>
    </dgm:pt>
    <dgm:pt modelId="{52C6961A-6B5D-404E-8206-E2C7EE810A52}" type="pres">
      <dgm:prSet presAssocID="{578376DD-277D-7C48-81DC-653553CEFEB4}" presName="linearFlow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en-US"/>
        </a:p>
      </dgm:t>
    </dgm:pt>
    <dgm:pt modelId="{42962519-E56B-D844-8428-327BA0CD28D2}" type="pres">
      <dgm:prSet presAssocID="{062668BE-90E9-8D4E-93B8-F20A2DC30EAC}" presName="composite" presStyleCnt="0"/>
      <dgm:spPr/>
    </dgm:pt>
    <dgm:pt modelId="{89D71017-761E-F847-94A3-56D0A9B0A24E}" type="pres">
      <dgm:prSet presAssocID="{062668BE-90E9-8D4E-93B8-F20A2DC30EAC}" presName="parentText" presStyleLbl="alignNode1" presStyleIdx="0" presStyleCnt="2" custScaleX="119115" custLinFactNeighborX="1826" custLinFactNeighborY="-952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5E6C8095-CAB7-1949-B94A-16DF7A304A8C}" type="pres">
      <dgm:prSet presAssocID="{062668BE-90E9-8D4E-93B8-F20A2DC30EAC}" presName="descendantText" presStyleLbl="alignAcc1" presStyleIdx="0" presStyleCnt="2" custScaleX="75533" custScaleY="85155" custLinFactNeighborX="-5592" custLinFactNeighborY="-7171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AD46E83A-77D7-274B-A723-78A9679D4B0E}" type="pres">
      <dgm:prSet presAssocID="{98D89EF4-E7BD-1440-91FF-47A42BFE2036}" presName="sp" presStyleCnt="0"/>
      <dgm:spPr/>
    </dgm:pt>
    <dgm:pt modelId="{4BC3F310-0DE4-2043-AB65-D7EB092DB23B}" type="pres">
      <dgm:prSet presAssocID="{F43E674B-A107-DF4B-9EFD-D823CAD502BA}" presName="composite" presStyleCnt="0"/>
      <dgm:spPr/>
      <dgm:t>
        <a:bodyPr/>
        <a:lstStyle/>
        <a:p>
          <a:endParaRPr lang="en-US"/>
        </a:p>
      </dgm:t>
    </dgm:pt>
    <dgm:pt modelId="{9E9B7BBD-0469-784A-8F00-DE538D0759AD}" type="pres">
      <dgm:prSet presAssocID="{F43E674B-A107-DF4B-9EFD-D823CAD502BA}" presName="parentText" presStyleLbl="alignNode1" presStyleIdx="1" presStyleCnt="2" custScaleX="121331" custLinFactNeighborX="2934" custLinFactNeighborY="-7011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87D92880-A8D0-D042-BD32-8C2E8F413D3E}" type="pres">
      <dgm:prSet presAssocID="{F43E674B-A107-DF4B-9EFD-D823CAD502BA}" presName="descendantText" presStyleLbl="alignAcc1" presStyleIdx="1" presStyleCnt="2" custScaleX="76323" custScaleY="85155" custLinFactNeighborX="-5212" custLinFactNeighborY="-1811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D461C295-5F24-B14B-BDDC-16876F1728F9}" srcId="{062668BE-90E9-8D4E-93B8-F20A2DC30EAC}" destId="{158043F8-675D-994E-A478-A0626B1ACDC6}" srcOrd="3" destOrd="0" parTransId="{83081E97-945D-8C47-9DCB-2CBB9C728BD7}" sibTransId="{CAAA37AD-2BD2-BA48-9DCD-AE70152BFFFF}"/>
    <dgm:cxn modelId="{021F88D3-C579-DC41-B46E-E8E944B5B97F}" type="presOf" srcId="{0E9DB17E-01B7-5246-A0D6-3F9EBB299968}" destId="{87D92880-A8D0-D042-BD32-8C2E8F413D3E}" srcOrd="0" destOrd="1" presId="urn:microsoft.com/office/officeart/2005/8/layout/chevron2"/>
    <dgm:cxn modelId="{160D2678-EC36-7F46-9131-A475D3D651E0}" srcId="{F43E674B-A107-DF4B-9EFD-D823CAD502BA}" destId="{2B7F9C90-7FB3-4940-B870-541619C49125}" srcOrd="0" destOrd="0" parTransId="{4249BC22-206B-F946-BD48-E386FCFFC8E9}" sibTransId="{5ED81182-8601-6E44-AFA0-BD61D82354A3}"/>
    <dgm:cxn modelId="{5EAA7FCD-71BF-A34A-B9C9-E202738A4689}" srcId="{F43E674B-A107-DF4B-9EFD-D823CAD502BA}" destId="{A500AEA8-C9EC-3744-82EA-10B67A5A945F}" srcOrd="2" destOrd="0" parTransId="{A856017C-9E5B-074D-AEB8-DCCC1E53D122}" sibTransId="{1C8A41ED-E785-9B41-9915-A72701E24B6D}"/>
    <dgm:cxn modelId="{CEABE86B-C016-7A46-923A-306AA27960A2}" type="presOf" srcId="{A500AEA8-C9EC-3744-82EA-10B67A5A945F}" destId="{87D92880-A8D0-D042-BD32-8C2E8F413D3E}" srcOrd="0" destOrd="2" presId="urn:microsoft.com/office/officeart/2005/8/layout/chevron2"/>
    <dgm:cxn modelId="{4CD5F352-8D6A-E04F-834E-FF96C96980E4}" srcId="{062668BE-90E9-8D4E-93B8-F20A2DC30EAC}" destId="{CDBE67AF-7735-0F4D-8329-981B5B39E64C}" srcOrd="1" destOrd="0" parTransId="{F9756A54-3BDA-6B47-95FA-62491902484F}" sibTransId="{A8DEB94C-9A7D-B549-888C-D1AB2EB4271D}"/>
    <dgm:cxn modelId="{DCAE1C39-8EEF-664B-81D9-A359CEAE814B}" type="presOf" srcId="{062668BE-90E9-8D4E-93B8-F20A2DC30EAC}" destId="{89D71017-761E-F847-94A3-56D0A9B0A24E}" srcOrd="0" destOrd="0" presId="urn:microsoft.com/office/officeart/2005/8/layout/chevron2"/>
    <dgm:cxn modelId="{76CA5694-4CDA-AB43-AF9D-8E7F6E9A675C}" srcId="{062668BE-90E9-8D4E-93B8-F20A2DC30EAC}" destId="{85CC7AD2-0447-D949-9A05-F4CA55ABFDC4}" srcOrd="2" destOrd="0" parTransId="{1B841000-AEDC-8141-B41E-639F9093B8F2}" sibTransId="{37FAC019-F7C4-154B-9BAC-E412BF2AE9D0}"/>
    <dgm:cxn modelId="{7ACC1B62-684F-1D47-820C-C14BD1025558}" srcId="{578376DD-277D-7C48-81DC-653553CEFEB4}" destId="{062668BE-90E9-8D4E-93B8-F20A2DC30EAC}" srcOrd="0" destOrd="0" parTransId="{C573A246-487D-3142-B4D4-A30C2D5DB496}" sibTransId="{98D89EF4-E7BD-1440-91FF-47A42BFE2036}"/>
    <dgm:cxn modelId="{D6A08010-8DA8-4346-A442-67E7A9428C73}" type="presOf" srcId="{CDBE67AF-7735-0F4D-8329-981B5B39E64C}" destId="{5E6C8095-CAB7-1949-B94A-16DF7A304A8C}" srcOrd="0" destOrd="1" presId="urn:microsoft.com/office/officeart/2005/8/layout/chevron2"/>
    <dgm:cxn modelId="{27D134A2-7735-D746-8430-C5A8914A151E}" type="presOf" srcId="{578376DD-277D-7C48-81DC-653553CEFEB4}" destId="{52C6961A-6B5D-404E-8206-E2C7EE810A52}" srcOrd="0" destOrd="0" presId="urn:microsoft.com/office/officeart/2005/8/layout/chevron2"/>
    <dgm:cxn modelId="{AB59295B-965E-3D4C-AC17-F7C02CB187C1}" srcId="{F43E674B-A107-DF4B-9EFD-D823CAD502BA}" destId="{0E9DB17E-01B7-5246-A0D6-3F9EBB299968}" srcOrd="1" destOrd="0" parTransId="{577745E3-E9C9-E949-A4ED-6F1339F1CA99}" sibTransId="{94ACAD15-002C-8545-A4A6-DEF749A287CF}"/>
    <dgm:cxn modelId="{7F1DB0A3-B7F6-CE48-92F3-6AD2B6FCF4EF}" type="presOf" srcId="{F43E674B-A107-DF4B-9EFD-D823CAD502BA}" destId="{9E9B7BBD-0469-784A-8F00-DE538D0759AD}" srcOrd="0" destOrd="0" presId="urn:microsoft.com/office/officeart/2005/8/layout/chevron2"/>
    <dgm:cxn modelId="{A59746C7-70F9-6E48-ABD2-5EC06C817E2C}" type="presOf" srcId="{158043F8-675D-994E-A478-A0626B1ACDC6}" destId="{5E6C8095-CAB7-1949-B94A-16DF7A304A8C}" srcOrd="0" destOrd="3" presId="urn:microsoft.com/office/officeart/2005/8/layout/chevron2"/>
    <dgm:cxn modelId="{E9DEE8B7-DCD5-4848-9FB3-9F840AA594F5}" srcId="{062668BE-90E9-8D4E-93B8-F20A2DC30EAC}" destId="{E49B05FA-9620-CA4B-967A-717D7A2D8EE6}" srcOrd="0" destOrd="0" parTransId="{398C4A83-611C-134E-B02D-30C608FABFF7}" sibTransId="{D3306E14-A65E-AC4E-B239-759BB48D862F}"/>
    <dgm:cxn modelId="{D04859AA-7483-F441-9966-25DFB1ED7B32}" type="presOf" srcId="{E49B05FA-9620-CA4B-967A-717D7A2D8EE6}" destId="{5E6C8095-CAB7-1949-B94A-16DF7A304A8C}" srcOrd="0" destOrd="0" presId="urn:microsoft.com/office/officeart/2005/8/layout/chevron2"/>
    <dgm:cxn modelId="{CE0E6E54-A860-6E4F-8A4E-AD7FC7AED1B3}" type="presOf" srcId="{85CC7AD2-0447-D949-9A05-F4CA55ABFDC4}" destId="{5E6C8095-CAB7-1949-B94A-16DF7A304A8C}" srcOrd="0" destOrd="2" presId="urn:microsoft.com/office/officeart/2005/8/layout/chevron2"/>
    <dgm:cxn modelId="{13420266-D42C-AE43-9F26-60A521322A82}" srcId="{578376DD-277D-7C48-81DC-653553CEFEB4}" destId="{F43E674B-A107-DF4B-9EFD-D823CAD502BA}" srcOrd="1" destOrd="0" parTransId="{02A50E48-ED62-CB41-826E-73BAAE3879BC}" sibTransId="{48321DB6-0BCE-4141-A9DF-022D459C26D7}"/>
    <dgm:cxn modelId="{5E9D1D86-CEE2-6E44-AD37-7C40DCF5F8CF}" type="presOf" srcId="{2B7F9C90-7FB3-4940-B870-541619C49125}" destId="{87D92880-A8D0-D042-BD32-8C2E8F413D3E}" srcOrd="0" destOrd="0" presId="urn:microsoft.com/office/officeart/2005/8/layout/chevron2"/>
    <dgm:cxn modelId="{F1078DF5-BC55-EF4C-A2EA-E1AD96AE88A6}" type="presParOf" srcId="{52C6961A-6B5D-404E-8206-E2C7EE810A52}" destId="{42962519-E56B-D844-8428-327BA0CD28D2}" srcOrd="0" destOrd="0" presId="urn:microsoft.com/office/officeart/2005/8/layout/chevron2"/>
    <dgm:cxn modelId="{A015428D-8BDF-104E-A721-3750D27EC5BD}" type="presParOf" srcId="{42962519-E56B-D844-8428-327BA0CD28D2}" destId="{89D71017-761E-F847-94A3-56D0A9B0A24E}" srcOrd="0" destOrd="0" presId="urn:microsoft.com/office/officeart/2005/8/layout/chevron2"/>
    <dgm:cxn modelId="{ACF55012-A418-574F-A424-A29664E10225}" type="presParOf" srcId="{42962519-E56B-D844-8428-327BA0CD28D2}" destId="{5E6C8095-CAB7-1949-B94A-16DF7A304A8C}" srcOrd="1" destOrd="0" presId="urn:microsoft.com/office/officeart/2005/8/layout/chevron2"/>
    <dgm:cxn modelId="{ED3F9386-3AD4-1147-A419-392A9F46DC7A}" type="presParOf" srcId="{52C6961A-6B5D-404E-8206-E2C7EE810A52}" destId="{AD46E83A-77D7-274B-A723-78A9679D4B0E}" srcOrd="1" destOrd="0" presId="urn:microsoft.com/office/officeart/2005/8/layout/chevron2"/>
    <dgm:cxn modelId="{8A272C52-368A-8841-ADA7-B487C82DF654}" type="presParOf" srcId="{52C6961A-6B5D-404E-8206-E2C7EE810A52}" destId="{4BC3F310-0DE4-2043-AB65-D7EB092DB23B}" srcOrd="2" destOrd="0" presId="urn:microsoft.com/office/officeart/2005/8/layout/chevron2"/>
    <dgm:cxn modelId="{FF868191-FFE0-FD4A-83FE-5A82908BE196}" type="presParOf" srcId="{4BC3F310-0DE4-2043-AB65-D7EB092DB23B}" destId="{9E9B7BBD-0469-784A-8F00-DE538D0759AD}" srcOrd="0" destOrd="0" presId="urn:microsoft.com/office/officeart/2005/8/layout/chevron2"/>
    <dgm:cxn modelId="{D3300CB5-D194-0746-AE77-F4467EB49928}" type="presParOf" srcId="{4BC3F310-0DE4-2043-AB65-D7EB092DB23B}" destId="{87D92880-A8D0-D042-BD32-8C2E8F413D3E}" srcOrd="1" destOrd="0" presId="urn:microsoft.com/office/officeart/2005/8/layout/chevron2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30346CE8-3589-3649-B8F2-AE8839D0C65C}" type="doc">
      <dgm:prSet loTypeId="urn:microsoft.com/office/officeart/2005/8/layout/chevron2" loCatId="" qsTypeId="urn:microsoft.com/office/officeart/2005/8/quickstyle/simple4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7BB1D59E-5387-8340-870A-2081519139D8}">
      <dgm:prSet phldrT="[Text]" custT="1"/>
      <dgm:spPr/>
      <dgm:t>
        <a:bodyPr/>
        <a:lstStyle/>
        <a:p>
          <a:r>
            <a:rPr lang="en-US" sz="2600" dirty="0" smtClean="0">
              <a:solidFill>
                <a:srgbClr val="FFFFFF"/>
              </a:solidFill>
            </a:rPr>
            <a:t>Identify </a:t>
          </a:r>
          <a:r>
            <a:rPr lang="en-US" sz="2600" dirty="0" err="1" smtClean="0">
              <a:solidFill>
                <a:srgbClr val="FFFFFF"/>
              </a:solidFill>
            </a:rPr>
            <a:t>DNAm</a:t>
          </a:r>
          <a:r>
            <a:rPr lang="en-US" sz="2600" dirty="0" smtClean="0">
              <a:solidFill>
                <a:srgbClr val="FFFFFF"/>
              </a:solidFill>
            </a:rPr>
            <a:t> signature</a:t>
          </a:r>
          <a:endParaRPr lang="en-US" sz="2600" dirty="0">
            <a:solidFill>
              <a:srgbClr val="FFFFFF"/>
            </a:solidFill>
          </a:endParaRPr>
        </a:p>
      </dgm:t>
    </dgm:pt>
    <dgm:pt modelId="{E042DBDC-7556-7F42-BA7E-F773E682C556}" type="parTrans" cxnId="{0D891B4C-216F-8F48-BB56-F3D1BE6E03EF}">
      <dgm:prSet/>
      <dgm:spPr/>
      <dgm:t>
        <a:bodyPr/>
        <a:lstStyle/>
        <a:p>
          <a:endParaRPr lang="en-US"/>
        </a:p>
      </dgm:t>
    </dgm:pt>
    <dgm:pt modelId="{84649F7E-062F-754E-B505-A823192D8E3A}" type="sibTrans" cxnId="{0D891B4C-216F-8F48-BB56-F3D1BE6E03EF}">
      <dgm:prSet/>
      <dgm:spPr/>
      <dgm:t>
        <a:bodyPr/>
        <a:lstStyle/>
        <a:p>
          <a:endParaRPr lang="en-US"/>
        </a:p>
      </dgm:t>
    </dgm:pt>
    <dgm:pt modelId="{115E817D-2B76-9043-9622-68B44E408F81}">
      <dgm:prSet phldrT="[Text]" custT="1"/>
      <dgm:spPr/>
      <dgm:t>
        <a:bodyPr/>
        <a:lstStyle/>
        <a:p>
          <a:r>
            <a:rPr lang="en-US" sz="2400" dirty="0" smtClean="0"/>
            <a:t>Identify significant differentially methylated </a:t>
          </a:r>
          <a:r>
            <a:rPr lang="en-US" sz="2400" dirty="0" err="1" smtClean="0"/>
            <a:t>CpG</a:t>
          </a:r>
          <a:r>
            <a:rPr lang="en-US" sz="2400" dirty="0" smtClean="0"/>
            <a:t> sites</a:t>
          </a:r>
          <a:endParaRPr lang="en-US" sz="2400" dirty="0"/>
        </a:p>
      </dgm:t>
    </dgm:pt>
    <dgm:pt modelId="{3CAA1D6C-9C05-8F46-8815-C23BE390AE4D}" type="parTrans" cxnId="{898AC106-00EA-0846-8E0D-EEA147F173CE}">
      <dgm:prSet/>
      <dgm:spPr/>
      <dgm:t>
        <a:bodyPr/>
        <a:lstStyle/>
        <a:p>
          <a:endParaRPr lang="en-US"/>
        </a:p>
      </dgm:t>
    </dgm:pt>
    <dgm:pt modelId="{16C6B0ED-82A0-AB44-A761-18D96C6FC688}" type="sibTrans" cxnId="{898AC106-00EA-0846-8E0D-EEA147F173CE}">
      <dgm:prSet/>
      <dgm:spPr/>
      <dgm:t>
        <a:bodyPr/>
        <a:lstStyle/>
        <a:p>
          <a:endParaRPr lang="en-US"/>
        </a:p>
      </dgm:t>
    </dgm:pt>
    <dgm:pt modelId="{F2A931A4-8EE9-E64D-B8AE-7943185D13A5}">
      <dgm:prSet phldrT="[Text]" custT="1"/>
      <dgm:spPr/>
      <dgm:t>
        <a:bodyPr/>
        <a:lstStyle/>
        <a:p>
          <a:r>
            <a:rPr lang="en-US" sz="2600" dirty="0" smtClean="0">
              <a:solidFill>
                <a:srgbClr val="FFFFFF"/>
              </a:solidFill>
            </a:rPr>
            <a:t>Validate signature for classification</a:t>
          </a:r>
          <a:endParaRPr lang="en-US" sz="2600" dirty="0">
            <a:solidFill>
              <a:srgbClr val="FFFFFF"/>
            </a:solidFill>
          </a:endParaRPr>
        </a:p>
      </dgm:t>
    </dgm:pt>
    <dgm:pt modelId="{397AD5DA-1A26-F247-A177-8D61A1D55827}" type="parTrans" cxnId="{8D317717-879B-5349-B88B-709F17DCB20A}">
      <dgm:prSet/>
      <dgm:spPr/>
      <dgm:t>
        <a:bodyPr/>
        <a:lstStyle/>
        <a:p>
          <a:endParaRPr lang="en-US"/>
        </a:p>
      </dgm:t>
    </dgm:pt>
    <dgm:pt modelId="{3BD64CDC-7A25-4C46-BEF3-8A2B9A823CF6}" type="sibTrans" cxnId="{8D317717-879B-5349-B88B-709F17DCB20A}">
      <dgm:prSet/>
      <dgm:spPr/>
      <dgm:t>
        <a:bodyPr/>
        <a:lstStyle/>
        <a:p>
          <a:endParaRPr lang="en-US"/>
        </a:p>
      </dgm:t>
    </dgm:pt>
    <dgm:pt modelId="{62B14432-FA1A-1C41-AE10-11D844E3927C}">
      <dgm:prSet phldrT="[Text]" custT="1"/>
      <dgm:spPr/>
      <dgm:t>
        <a:bodyPr/>
        <a:lstStyle/>
        <a:p>
          <a:r>
            <a:rPr lang="en-US" sz="2400" dirty="0" smtClean="0">
              <a:solidFill>
                <a:srgbClr val="000000"/>
              </a:solidFill>
            </a:rPr>
            <a:t>Blood cell-type comparison</a:t>
          </a:r>
          <a:endParaRPr lang="en-US" sz="2400" dirty="0"/>
        </a:p>
      </dgm:t>
    </dgm:pt>
    <dgm:pt modelId="{CFF43B8F-F438-2046-BD67-936E689300B5}" type="parTrans" cxnId="{73A95FF2-F10E-9240-9EBB-F03B01ED6723}">
      <dgm:prSet/>
      <dgm:spPr/>
      <dgm:t>
        <a:bodyPr/>
        <a:lstStyle/>
        <a:p>
          <a:endParaRPr lang="en-US"/>
        </a:p>
      </dgm:t>
    </dgm:pt>
    <dgm:pt modelId="{5D46A605-29FA-D145-ACED-248E3156590F}" type="sibTrans" cxnId="{73A95FF2-F10E-9240-9EBB-F03B01ED6723}">
      <dgm:prSet/>
      <dgm:spPr/>
      <dgm:t>
        <a:bodyPr/>
        <a:lstStyle/>
        <a:p>
          <a:endParaRPr lang="en-US"/>
        </a:p>
      </dgm:t>
    </dgm:pt>
    <dgm:pt modelId="{4E9C5AFF-06BB-3A4C-9B4B-2CCC5642EC80}">
      <dgm:prSet phldrT="[Text]" custT="1"/>
      <dgm:spPr/>
      <dgm:t>
        <a:bodyPr/>
        <a:lstStyle/>
        <a:p>
          <a:r>
            <a:rPr lang="en-US" sz="2400" dirty="0" smtClean="0"/>
            <a:t>Use signatures to build models for classification </a:t>
          </a:r>
          <a:r>
            <a:rPr lang="en-US" sz="2400" dirty="0" smtClean="0">
              <a:solidFill>
                <a:srgbClr val="000000"/>
              </a:solidFill>
            </a:rPr>
            <a:t>of variants/test cases/independent controls [GEO] (sensitivity/specificity)</a:t>
          </a:r>
          <a:endParaRPr lang="en-US" sz="2400" dirty="0"/>
        </a:p>
      </dgm:t>
    </dgm:pt>
    <dgm:pt modelId="{E1B9EA34-2D75-BB47-89B0-A806FD75D55D}" type="parTrans" cxnId="{7C20FFF0-6455-5C4A-B919-AFF470F11AEE}">
      <dgm:prSet/>
      <dgm:spPr/>
      <dgm:t>
        <a:bodyPr/>
        <a:lstStyle/>
        <a:p>
          <a:endParaRPr lang="en-US"/>
        </a:p>
      </dgm:t>
    </dgm:pt>
    <dgm:pt modelId="{388418F1-B029-7540-B149-5A1FE4CF5604}" type="sibTrans" cxnId="{7C20FFF0-6455-5C4A-B919-AFF470F11AEE}">
      <dgm:prSet/>
      <dgm:spPr/>
      <dgm:t>
        <a:bodyPr/>
        <a:lstStyle/>
        <a:p>
          <a:endParaRPr lang="en-US"/>
        </a:p>
      </dgm:t>
    </dgm:pt>
    <dgm:pt modelId="{CB22585C-C843-DB42-BA11-D04E84F7D181}">
      <dgm:prSet custT="1"/>
      <dgm:spPr/>
      <dgm:t>
        <a:bodyPr/>
        <a:lstStyle/>
        <a:p>
          <a:r>
            <a:rPr lang="en-US" sz="2400" dirty="0" smtClean="0">
              <a:solidFill>
                <a:srgbClr val="000000"/>
              </a:solidFill>
            </a:rPr>
            <a:t>Pathway enrichment analysis of signatures</a:t>
          </a:r>
          <a:endParaRPr lang="en-US" sz="2400" dirty="0">
            <a:solidFill>
              <a:srgbClr val="000000"/>
            </a:solidFill>
          </a:endParaRPr>
        </a:p>
      </dgm:t>
    </dgm:pt>
    <dgm:pt modelId="{03293363-A26C-B24D-B0A9-3D151D1C0FCF}" type="sibTrans" cxnId="{407E8B35-8184-EF46-94FF-BDA01D28C06A}">
      <dgm:prSet/>
      <dgm:spPr/>
      <dgm:t>
        <a:bodyPr/>
        <a:lstStyle/>
        <a:p>
          <a:endParaRPr lang="en-US"/>
        </a:p>
      </dgm:t>
    </dgm:pt>
    <dgm:pt modelId="{276971D3-9EAC-664A-B55B-13E1C9AD0DF6}" type="parTrans" cxnId="{407E8B35-8184-EF46-94FF-BDA01D28C06A}">
      <dgm:prSet/>
      <dgm:spPr/>
      <dgm:t>
        <a:bodyPr/>
        <a:lstStyle/>
        <a:p>
          <a:endParaRPr lang="en-US"/>
        </a:p>
      </dgm:t>
    </dgm:pt>
    <dgm:pt modelId="{42AEA550-A127-754E-8B1F-60C97849A210}">
      <dgm:prSet custT="1"/>
      <dgm:spPr/>
      <dgm:t>
        <a:bodyPr/>
        <a:lstStyle/>
        <a:p>
          <a:r>
            <a:rPr lang="en-US" sz="2400" dirty="0" err="1" smtClean="0"/>
            <a:t>Limma</a:t>
          </a:r>
          <a:r>
            <a:rPr lang="en-US" sz="2400" dirty="0" smtClean="0"/>
            <a:t> </a:t>
          </a:r>
          <a:r>
            <a:rPr lang="en-US" sz="2400" dirty="0"/>
            <a:t>regression </a:t>
          </a:r>
          <a:r>
            <a:rPr lang="en-US" sz="2400" dirty="0" smtClean="0"/>
            <a:t>models with covariates</a:t>
          </a:r>
          <a:endParaRPr lang="en-US" sz="2400" dirty="0"/>
        </a:p>
      </dgm:t>
    </dgm:pt>
    <dgm:pt modelId="{C7D7FFC4-BA2A-6241-BF2E-35D26F3DA8AD}" type="parTrans" cxnId="{0FD912F6-7FD2-1A41-A48A-E52CDF3C9583}">
      <dgm:prSet/>
      <dgm:spPr/>
      <dgm:t>
        <a:bodyPr/>
        <a:lstStyle/>
        <a:p>
          <a:endParaRPr lang="en-US"/>
        </a:p>
      </dgm:t>
    </dgm:pt>
    <dgm:pt modelId="{1AC261D9-5F0C-F340-82C1-5C4BC7D88077}" type="sibTrans" cxnId="{0FD912F6-7FD2-1A41-A48A-E52CDF3C9583}">
      <dgm:prSet/>
      <dgm:spPr/>
      <dgm:t>
        <a:bodyPr/>
        <a:lstStyle/>
        <a:p>
          <a:endParaRPr lang="en-US"/>
        </a:p>
      </dgm:t>
    </dgm:pt>
    <dgm:pt modelId="{ACBF81FB-9A16-6A40-9B0A-2595AFC5CCDA}">
      <dgm:prSet custT="1"/>
      <dgm:spPr/>
      <dgm:t>
        <a:bodyPr/>
        <a:lstStyle/>
        <a:p>
          <a:r>
            <a:rPr lang="en-US" sz="2400" dirty="0" smtClean="0"/>
            <a:t>Mann</a:t>
          </a:r>
          <a:r>
            <a:rPr lang="en-US" sz="2400" dirty="0"/>
            <a:t>-Whitney U non-parametric </a:t>
          </a:r>
          <a:r>
            <a:rPr lang="en-US" sz="2400" dirty="0" smtClean="0"/>
            <a:t>tests</a:t>
          </a:r>
          <a:endParaRPr lang="en-US" sz="2400" dirty="0"/>
        </a:p>
      </dgm:t>
    </dgm:pt>
    <dgm:pt modelId="{10CC699F-2DD8-034E-B7B8-ABD0EFCA5874}" type="parTrans" cxnId="{F606DD6C-A8B9-0E46-85FB-534B2600D3DE}">
      <dgm:prSet/>
      <dgm:spPr/>
      <dgm:t>
        <a:bodyPr/>
        <a:lstStyle/>
        <a:p>
          <a:endParaRPr lang="en-US"/>
        </a:p>
      </dgm:t>
    </dgm:pt>
    <dgm:pt modelId="{EB6A3F7C-EBBC-DC46-8255-432B2039A6EB}" type="sibTrans" cxnId="{F606DD6C-A8B9-0E46-85FB-534B2600D3DE}">
      <dgm:prSet/>
      <dgm:spPr/>
      <dgm:t>
        <a:bodyPr/>
        <a:lstStyle/>
        <a:p>
          <a:endParaRPr lang="en-US"/>
        </a:p>
      </dgm:t>
    </dgm:pt>
    <dgm:pt modelId="{42CD7B35-8493-324E-A8EA-4B8654929CCB}">
      <dgm:prSet custT="1"/>
      <dgm:spPr/>
      <dgm:t>
        <a:bodyPr/>
        <a:lstStyle/>
        <a:p>
          <a:r>
            <a:rPr lang="en-US" sz="2400" dirty="0" smtClean="0"/>
            <a:t>Multiple </a:t>
          </a:r>
          <a:r>
            <a:rPr lang="en-US" sz="2400" dirty="0"/>
            <a:t>testing correction: FDR q &lt; </a:t>
          </a:r>
          <a:r>
            <a:rPr lang="en-US" sz="2400" dirty="0" smtClean="0"/>
            <a:t>0.05; effect size threshold: |</a:t>
          </a:r>
          <a:r>
            <a:rPr lang="en-US" sz="2400" dirty="0" err="1" smtClean="0"/>
            <a:t>Δ</a:t>
          </a:r>
          <a:r>
            <a:rPr lang="en-US" sz="2400" dirty="0" smtClean="0"/>
            <a:t>β|&gt;5%</a:t>
          </a:r>
          <a:endParaRPr lang="en-US" sz="2400" dirty="0"/>
        </a:p>
      </dgm:t>
    </dgm:pt>
    <dgm:pt modelId="{C881B068-1C09-384B-AADA-D428E7698902}" type="parTrans" cxnId="{3FF91430-178D-394A-A6FA-84012743C717}">
      <dgm:prSet/>
      <dgm:spPr/>
      <dgm:t>
        <a:bodyPr/>
        <a:lstStyle/>
        <a:p>
          <a:endParaRPr lang="en-US"/>
        </a:p>
      </dgm:t>
    </dgm:pt>
    <dgm:pt modelId="{7D09C11B-26DC-7E45-86EF-1973FFE5E6D5}" type="sibTrans" cxnId="{3FF91430-178D-394A-A6FA-84012743C717}">
      <dgm:prSet/>
      <dgm:spPr/>
      <dgm:t>
        <a:bodyPr/>
        <a:lstStyle/>
        <a:p>
          <a:endParaRPr lang="en-US"/>
        </a:p>
      </dgm:t>
    </dgm:pt>
    <dgm:pt modelId="{31E9751D-D8B6-4141-883F-3968636F22E2}" type="pres">
      <dgm:prSet presAssocID="{30346CE8-3589-3649-B8F2-AE8839D0C65C}" presName="linearFlow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en-US"/>
        </a:p>
      </dgm:t>
    </dgm:pt>
    <dgm:pt modelId="{3DE4BF42-7937-AE46-95BC-226AC8C4DA86}" type="pres">
      <dgm:prSet presAssocID="{7BB1D59E-5387-8340-870A-2081519139D8}" presName="composite" presStyleCnt="0"/>
      <dgm:spPr/>
    </dgm:pt>
    <dgm:pt modelId="{D3252512-A0CB-874A-B416-E7A05DAD3EB0}" type="pres">
      <dgm:prSet presAssocID="{7BB1D59E-5387-8340-870A-2081519139D8}" presName="parentText" presStyleLbl="alignNode1" presStyleIdx="0" presStyleCnt="2" custScaleX="122540" custLinFactNeighborX="-4085" custLinFactNeighborY="14848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04544CC2-E062-C643-A839-1D9EC07980D4}" type="pres">
      <dgm:prSet presAssocID="{7BB1D59E-5387-8340-870A-2081519139D8}" presName="descendantText" presStyleLbl="alignAcc1" presStyleIdx="0" presStyleCnt="2" custScaleX="95789" custScaleY="102604" custLinFactNeighborX="4931" custLinFactNeighborY="2275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5DB66FD8-51F2-8C4B-A89D-B826942BCA03}" type="pres">
      <dgm:prSet presAssocID="{84649F7E-062F-754E-B505-A823192D8E3A}" presName="sp" presStyleCnt="0"/>
      <dgm:spPr/>
    </dgm:pt>
    <dgm:pt modelId="{1C5B6390-E009-E843-9A4B-71E9D2B79709}" type="pres">
      <dgm:prSet presAssocID="{F2A931A4-8EE9-E64D-B8AE-7943185D13A5}" presName="composite" presStyleCnt="0"/>
      <dgm:spPr/>
    </dgm:pt>
    <dgm:pt modelId="{FAF63370-BCBC-9E40-B28D-8E52ACD4E1CA}" type="pres">
      <dgm:prSet presAssocID="{F2A931A4-8EE9-E64D-B8AE-7943185D13A5}" presName="parentText" presStyleLbl="alignNode1" presStyleIdx="1" presStyleCnt="2" custScaleX="120213" custScaleY="106871" custLinFactNeighborX="-2341" custLinFactNeighborY="964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EB66F9E8-C6DB-AA4C-BE42-2B6D51C1517B}" type="pres">
      <dgm:prSet presAssocID="{F2A931A4-8EE9-E64D-B8AE-7943185D13A5}" presName="descendantText" presStyleLbl="alignAcc1" presStyleIdx="1" presStyleCnt="2" custScaleX="76268" custScaleY="91738" custLinFactNeighborX="-6445" custLinFactNeighborY="-6640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F606DD6C-A8B9-0E46-85FB-534B2600D3DE}" srcId="{7BB1D59E-5387-8340-870A-2081519139D8}" destId="{ACBF81FB-9A16-6A40-9B0A-2595AFC5CCDA}" srcOrd="2" destOrd="0" parTransId="{10CC699F-2DD8-034E-B7B8-ABD0EFCA5874}" sibTransId="{EB6A3F7C-EBBC-DC46-8255-432B2039A6EB}"/>
    <dgm:cxn modelId="{43A2EB9B-75E7-8542-B5EE-BC53F09D983E}" type="presOf" srcId="{7BB1D59E-5387-8340-870A-2081519139D8}" destId="{D3252512-A0CB-874A-B416-E7A05DAD3EB0}" srcOrd="0" destOrd="0" presId="urn:microsoft.com/office/officeart/2005/8/layout/chevron2"/>
    <dgm:cxn modelId="{0FD912F6-7FD2-1A41-A48A-E52CDF3C9583}" srcId="{7BB1D59E-5387-8340-870A-2081519139D8}" destId="{42AEA550-A127-754E-8B1F-60C97849A210}" srcOrd="1" destOrd="0" parTransId="{C7D7FFC4-BA2A-6241-BF2E-35D26F3DA8AD}" sibTransId="{1AC261D9-5F0C-F340-82C1-5C4BC7D88077}"/>
    <dgm:cxn modelId="{8D317717-879B-5349-B88B-709F17DCB20A}" srcId="{30346CE8-3589-3649-B8F2-AE8839D0C65C}" destId="{F2A931A4-8EE9-E64D-B8AE-7943185D13A5}" srcOrd="1" destOrd="0" parTransId="{397AD5DA-1A26-F247-A177-8D61A1D55827}" sibTransId="{3BD64CDC-7A25-4C46-BEF3-8A2B9A823CF6}"/>
    <dgm:cxn modelId="{2768F6BF-29E2-C243-9DF9-56D3D0DB3AB3}" type="presOf" srcId="{62B14432-FA1A-1C41-AE10-11D844E3927C}" destId="{EB66F9E8-C6DB-AA4C-BE42-2B6D51C1517B}" srcOrd="0" destOrd="0" presId="urn:microsoft.com/office/officeart/2005/8/layout/chevron2"/>
    <dgm:cxn modelId="{8C126393-CC87-F44E-AB0E-B9E8DA678A6F}" type="presOf" srcId="{CB22585C-C843-DB42-BA11-D04E84F7D181}" destId="{EB66F9E8-C6DB-AA4C-BE42-2B6D51C1517B}" srcOrd="0" destOrd="2" presId="urn:microsoft.com/office/officeart/2005/8/layout/chevron2"/>
    <dgm:cxn modelId="{695754A5-FA9B-BC44-B9DD-F69DE564EBCD}" type="presOf" srcId="{42CD7B35-8493-324E-A8EA-4B8654929CCB}" destId="{04544CC2-E062-C643-A839-1D9EC07980D4}" srcOrd="0" destOrd="3" presId="urn:microsoft.com/office/officeart/2005/8/layout/chevron2"/>
    <dgm:cxn modelId="{898AC106-00EA-0846-8E0D-EEA147F173CE}" srcId="{7BB1D59E-5387-8340-870A-2081519139D8}" destId="{115E817D-2B76-9043-9622-68B44E408F81}" srcOrd="0" destOrd="0" parTransId="{3CAA1D6C-9C05-8F46-8815-C23BE390AE4D}" sibTransId="{16C6B0ED-82A0-AB44-A761-18D96C6FC688}"/>
    <dgm:cxn modelId="{73A95FF2-F10E-9240-9EBB-F03B01ED6723}" srcId="{F2A931A4-8EE9-E64D-B8AE-7943185D13A5}" destId="{62B14432-FA1A-1C41-AE10-11D844E3927C}" srcOrd="0" destOrd="0" parTransId="{CFF43B8F-F438-2046-BD67-936E689300B5}" sibTransId="{5D46A605-29FA-D145-ACED-248E3156590F}"/>
    <dgm:cxn modelId="{407E8B35-8184-EF46-94FF-BDA01D28C06A}" srcId="{F2A931A4-8EE9-E64D-B8AE-7943185D13A5}" destId="{CB22585C-C843-DB42-BA11-D04E84F7D181}" srcOrd="2" destOrd="0" parTransId="{276971D3-9EAC-664A-B55B-13E1C9AD0DF6}" sibTransId="{03293363-A26C-B24D-B0A9-3D151D1C0FCF}"/>
    <dgm:cxn modelId="{F3EAC12C-7676-1F45-8813-23A14BD8FCFD}" type="presOf" srcId="{30346CE8-3589-3649-B8F2-AE8839D0C65C}" destId="{31E9751D-D8B6-4141-883F-3968636F22E2}" srcOrd="0" destOrd="0" presId="urn:microsoft.com/office/officeart/2005/8/layout/chevron2"/>
    <dgm:cxn modelId="{3FF91430-178D-394A-A6FA-84012743C717}" srcId="{7BB1D59E-5387-8340-870A-2081519139D8}" destId="{42CD7B35-8493-324E-A8EA-4B8654929CCB}" srcOrd="3" destOrd="0" parTransId="{C881B068-1C09-384B-AADA-D428E7698902}" sibTransId="{7D09C11B-26DC-7E45-86EF-1973FFE5E6D5}"/>
    <dgm:cxn modelId="{7C20FFF0-6455-5C4A-B919-AFF470F11AEE}" srcId="{F2A931A4-8EE9-E64D-B8AE-7943185D13A5}" destId="{4E9C5AFF-06BB-3A4C-9B4B-2CCC5642EC80}" srcOrd="1" destOrd="0" parTransId="{E1B9EA34-2D75-BB47-89B0-A806FD75D55D}" sibTransId="{388418F1-B029-7540-B149-5A1FE4CF5604}"/>
    <dgm:cxn modelId="{8B53E492-F025-D540-BA71-F8767797841B}" type="presOf" srcId="{F2A931A4-8EE9-E64D-B8AE-7943185D13A5}" destId="{FAF63370-BCBC-9E40-B28D-8E52ACD4E1CA}" srcOrd="0" destOrd="0" presId="urn:microsoft.com/office/officeart/2005/8/layout/chevron2"/>
    <dgm:cxn modelId="{D458BD9F-9814-D140-A77E-B40A052ED090}" type="presOf" srcId="{115E817D-2B76-9043-9622-68B44E408F81}" destId="{04544CC2-E062-C643-A839-1D9EC07980D4}" srcOrd="0" destOrd="0" presId="urn:microsoft.com/office/officeart/2005/8/layout/chevron2"/>
    <dgm:cxn modelId="{0D891B4C-216F-8F48-BB56-F3D1BE6E03EF}" srcId="{30346CE8-3589-3649-B8F2-AE8839D0C65C}" destId="{7BB1D59E-5387-8340-870A-2081519139D8}" srcOrd="0" destOrd="0" parTransId="{E042DBDC-7556-7F42-BA7E-F773E682C556}" sibTransId="{84649F7E-062F-754E-B505-A823192D8E3A}"/>
    <dgm:cxn modelId="{53FB6195-B87A-8F4F-ADB9-30A47007F630}" type="presOf" srcId="{42AEA550-A127-754E-8B1F-60C97849A210}" destId="{04544CC2-E062-C643-A839-1D9EC07980D4}" srcOrd="0" destOrd="1" presId="urn:microsoft.com/office/officeart/2005/8/layout/chevron2"/>
    <dgm:cxn modelId="{64EA8E38-0DD5-2542-A2D9-E90597D60D88}" type="presOf" srcId="{4E9C5AFF-06BB-3A4C-9B4B-2CCC5642EC80}" destId="{EB66F9E8-C6DB-AA4C-BE42-2B6D51C1517B}" srcOrd="0" destOrd="1" presId="urn:microsoft.com/office/officeart/2005/8/layout/chevron2"/>
    <dgm:cxn modelId="{103A8574-6D2A-E04E-B1BC-F665B634ECCB}" type="presOf" srcId="{ACBF81FB-9A16-6A40-9B0A-2595AFC5CCDA}" destId="{04544CC2-E062-C643-A839-1D9EC07980D4}" srcOrd="0" destOrd="2" presId="urn:microsoft.com/office/officeart/2005/8/layout/chevron2"/>
    <dgm:cxn modelId="{B632FDC7-8808-144E-ACAC-F82B3ACBFFAD}" type="presParOf" srcId="{31E9751D-D8B6-4141-883F-3968636F22E2}" destId="{3DE4BF42-7937-AE46-95BC-226AC8C4DA86}" srcOrd="0" destOrd="0" presId="urn:microsoft.com/office/officeart/2005/8/layout/chevron2"/>
    <dgm:cxn modelId="{CF5CD912-2EBF-2448-B58D-0B50B3479383}" type="presParOf" srcId="{3DE4BF42-7937-AE46-95BC-226AC8C4DA86}" destId="{D3252512-A0CB-874A-B416-E7A05DAD3EB0}" srcOrd="0" destOrd="0" presId="urn:microsoft.com/office/officeart/2005/8/layout/chevron2"/>
    <dgm:cxn modelId="{50ADFB30-C391-8C4A-BAAF-16FC39460799}" type="presParOf" srcId="{3DE4BF42-7937-AE46-95BC-226AC8C4DA86}" destId="{04544CC2-E062-C643-A839-1D9EC07980D4}" srcOrd="1" destOrd="0" presId="urn:microsoft.com/office/officeart/2005/8/layout/chevron2"/>
    <dgm:cxn modelId="{98A55974-4AFA-3B44-8159-E318E869AAE1}" type="presParOf" srcId="{31E9751D-D8B6-4141-883F-3968636F22E2}" destId="{5DB66FD8-51F2-8C4B-A89D-B826942BCA03}" srcOrd="1" destOrd="0" presId="urn:microsoft.com/office/officeart/2005/8/layout/chevron2"/>
    <dgm:cxn modelId="{A3840619-0BF8-7440-81A7-84E07EF38B23}" type="presParOf" srcId="{31E9751D-D8B6-4141-883F-3968636F22E2}" destId="{1C5B6390-E009-E843-9A4B-71E9D2B79709}" srcOrd="2" destOrd="0" presId="urn:microsoft.com/office/officeart/2005/8/layout/chevron2"/>
    <dgm:cxn modelId="{9EB740FC-AD9A-4746-A447-7ADD24A409A4}" type="presParOf" srcId="{1C5B6390-E009-E843-9A4B-71E9D2B79709}" destId="{FAF63370-BCBC-9E40-B28D-8E52ACD4E1CA}" srcOrd="0" destOrd="0" presId="urn:microsoft.com/office/officeart/2005/8/layout/chevron2"/>
    <dgm:cxn modelId="{90A89EE1-14E2-2542-9F23-6C12200FAA83}" type="presParOf" srcId="{1C5B6390-E009-E843-9A4B-71E9D2B79709}" destId="{EB66F9E8-C6DB-AA4C-BE42-2B6D51C1517B}" srcOrd="1" destOrd="0" presId="urn:microsoft.com/office/officeart/2005/8/layout/chevron2"/>
  </dgm:cxnLst>
  <dgm:bg/>
  <dgm:whole/>
  <dgm:extLst>
    <a:ext uri="http://schemas.microsoft.com/office/drawing/2008/diagram">
      <dsp:dataModelExt xmlns:dsp="http://schemas.microsoft.com/office/drawing/2008/diagram" relId="rId12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89D71017-761E-F847-94A3-56D0A9B0A24E}">
      <dsp:nvSpPr>
        <dsp:cNvPr id="0" name=""/>
        <dsp:cNvSpPr/>
      </dsp:nvSpPr>
      <dsp:spPr>
        <a:xfrm rot="5400000">
          <a:off x="424511" y="273151"/>
          <a:ext cx="3287114" cy="2740812"/>
        </a:xfrm>
        <a:prstGeom prst="chevron">
          <a:avLst/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51000"/>
                <a:satMod val="130000"/>
              </a:schemeClr>
            </a:gs>
            <a:gs pos="80000">
              <a:schemeClr val="accent1">
                <a:hueOff val="0"/>
                <a:satOff val="0"/>
                <a:lumOff val="0"/>
                <a:alphaOff val="0"/>
                <a:shade val="93000"/>
                <a:satMod val="13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shade val="94000"/>
                <a:satMod val="135000"/>
              </a:schemeClr>
            </a:gs>
          </a:gsLst>
          <a:lin ang="16200000" scaled="0"/>
        </a:gra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1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16510" tIns="16510" rIns="16510" bIns="16510" numCol="1" spcCol="1270" anchor="ctr" anchorCtr="0">
          <a:noAutofit/>
        </a:bodyPr>
        <a:lstStyle/>
        <a:p>
          <a:pPr lvl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600" kern="1200" dirty="0" smtClean="0">
              <a:solidFill>
                <a:schemeClr val="bg1"/>
              </a:solidFill>
            </a:rPr>
            <a:t>Pre-processing of raw data</a:t>
          </a:r>
        </a:p>
      </dsp:txBody>
      <dsp:txXfrm rot="-5400000">
        <a:off x="697662" y="1370406"/>
        <a:ext cx="2740812" cy="546302"/>
      </dsp:txXfrm>
    </dsp:sp>
    <dsp:sp modelId="{5E6C8095-CAB7-1949-B94A-16DF7A304A8C}">
      <dsp:nvSpPr>
        <dsp:cNvPr id="0" name=""/>
        <dsp:cNvSpPr/>
      </dsp:nvSpPr>
      <dsp:spPr>
        <a:xfrm rot="5400000">
          <a:off x="6221929" y="-2441232"/>
          <a:ext cx="1820399" cy="6728006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70688" tIns="15240" rIns="15240" bIns="15240" numCol="1" spcCol="1270" anchor="ctr" anchorCtr="0">
          <a:noAutofit/>
        </a:bodyPr>
        <a:lstStyle/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2400" kern="1200" dirty="0" smtClean="0"/>
            <a:t>Removal of cross-reactive probes</a:t>
          </a:r>
          <a:endParaRPr lang="en-US" sz="2400" kern="1200" dirty="0"/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2400" kern="1200" dirty="0" smtClean="0"/>
            <a:t>Removal of SNPs, </a:t>
          </a:r>
          <a:r>
            <a:rPr lang="en-US" sz="2400" kern="1200" dirty="0" err="1" smtClean="0"/>
            <a:t>chr</a:t>
          </a:r>
          <a:r>
            <a:rPr lang="en-US" sz="2400" kern="1200" dirty="0" smtClean="0"/>
            <a:t> X and Y</a:t>
          </a:r>
          <a:endParaRPr lang="en-US" sz="2400" kern="1200" dirty="0"/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2400" kern="1200" dirty="0" smtClean="0">
              <a:solidFill>
                <a:srgbClr val="000000"/>
              </a:solidFill>
            </a:rPr>
            <a:t>Normalization, batch correction </a:t>
          </a:r>
          <a:endParaRPr lang="en-US" sz="2400" kern="1200" dirty="0"/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2400" kern="1200" dirty="0" smtClean="0">
              <a:solidFill>
                <a:srgbClr val="000000"/>
              </a:solidFill>
            </a:rPr>
            <a:t>Filter by variance</a:t>
          </a:r>
          <a:endParaRPr lang="en-US" sz="2400" kern="1200" dirty="0"/>
        </a:p>
      </dsp:txBody>
      <dsp:txXfrm rot="-5400000">
        <a:off x="3768126" y="101436"/>
        <a:ext cx="6639141" cy="1642669"/>
      </dsp:txXfrm>
    </dsp:sp>
    <dsp:sp modelId="{9E9B7BBD-0469-784A-8F00-DE538D0759AD}">
      <dsp:nvSpPr>
        <dsp:cNvPr id="0" name=""/>
        <dsp:cNvSpPr/>
      </dsp:nvSpPr>
      <dsp:spPr>
        <a:xfrm rot="5400000">
          <a:off x="475500" y="3032430"/>
          <a:ext cx="3287114" cy="2791802"/>
        </a:xfrm>
        <a:prstGeom prst="chevron">
          <a:avLst/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51000"/>
                <a:satMod val="130000"/>
              </a:schemeClr>
            </a:gs>
            <a:gs pos="80000">
              <a:schemeClr val="accent1">
                <a:hueOff val="0"/>
                <a:satOff val="0"/>
                <a:lumOff val="0"/>
                <a:alphaOff val="0"/>
                <a:shade val="93000"/>
                <a:satMod val="13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shade val="94000"/>
                <a:satMod val="135000"/>
              </a:schemeClr>
            </a:gs>
          </a:gsLst>
          <a:lin ang="16200000" scaled="0"/>
        </a:gra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1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16510" tIns="16510" rIns="16510" bIns="16510" numCol="1" spcCol="1270" anchor="ctr" anchorCtr="0">
          <a:noAutofit/>
        </a:bodyPr>
        <a:lstStyle/>
        <a:p>
          <a:pPr lvl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600" kern="1200" dirty="0" smtClean="0">
              <a:solidFill>
                <a:srgbClr val="FFFFFF"/>
              </a:solidFill>
            </a:rPr>
            <a:t>Exploratory analysis</a:t>
          </a:r>
        </a:p>
      </dsp:txBody>
      <dsp:txXfrm rot="-5400000">
        <a:off x="723156" y="4180675"/>
        <a:ext cx="2791802" cy="495312"/>
      </dsp:txXfrm>
    </dsp:sp>
    <dsp:sp modelId="{87D92880-A8D0-D042-BD32-8C2E8F413D3E}">
      <dsp:nvSpPr>
        <dsp:cNvPr id="0" name=""/>
        <dsp:cNvSpPr/>
      </dsp:nvSpPr>
      <dsp:spPr>
        <a:xfrm rot="5400000">
          <a:off x="6323476" y="261778"/>
          <a:ext cx="1819442" cy="6869478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70688" tIns="15240" rIns="15240" bIns="15240" numCol="1" spcCol="1270" anchor="ctr" anchorCtr="0">
          <a:noAutofit/>
        </a:bodyPr>
        <a:lstStyle/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2400" kern="1200" dirty="0" smtClean="0"/>
            <a:t>Principal component analysis</a:t>
          </a:r>
          <a:endParaRPr lang="en-US" sz="2400" kern="1200" dirty="0"/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2400" kern="1200" dirty="0" smtClean="0"/>
            <a:t>Hierarchical clustering</a:t>
          </a:r>
          <a:endParaRPr lang="en-US" sz="2400" kern="1200" dirty="0"/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2400" kern="1200" dirty="0" smtClean="0"/>
            <a:t>Exploratory data analysis</a:t>
          </a:r>
          <a:endParaRPr lang="en-US" sz="2400" kern="1200" dirty="0"/>
        </a:p>
      </dsp:txBody>
      <dsp:txXfrm rot="-5400000">
        <a:off x="3798458" y="2875614"/>
        <a:ext cx="6780660" cy="1641806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D3252512-A0CB-874A-B416-E7A05DAD3EB0}">
      <dsp:nvSpPr>
        <dsp:cNvPr id="0" name=""/>
        <dsp:cNvSpPr/>
      </dsp:nvSpPr>
      <dsp:spPr>
        <a:xfrm rot="5400000">
          <a:off x="266661" y="798344"/>
          <a:ext cx="3472348" cy="2978510"/>
        </a:xfrm>
        <a:prstGeom prst="chevron">
          <a:avLst/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51000"/>
                <a:satMod val="130000"/>
              </a:schemeClr>
            </a:gs>
            <a:gs pos="80000">
              <a:schemeClr val="accent1">
                <a:hueOff val="0"/>
                <a:satOff val="0"/>
                <a:lumOff val="0"/>
                <a:alphaOff val="0"/>
                <a:shade val="93000"/>
                <a:satMod val="13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shade val="94000"/>
                <a:satMod val="135000"/>
              </a:schemeClr>
            </a:gs>
          </a:gsLst>
          <a:lin ang="16200000" scaled="0"/>
        </a:gra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1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16510" tIns="16510" rIns="16510" bIns="16510" numCol="1" spcCol="1270" anchor="ctr" anchorCtr="0">
          <a:noAutofit/>
        </a:bodyPr>
        <a:lstStyle/>
        <a:p>
          <a:pPr lvl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600" kern="1200" dirty="0" smtClean="0">
              <a:solidFill>
                <a:srgbClr val="FFFFFF"/>
              </a:solidFill>
            </a:rPr>
            <a:t>Identify </a:t>
          </a:r>
          <a:r>
            <a:rPr lang="en-US" sz="2600" kern="1200" dirty="0" err="1" smtClean="0">
              <a:solidFill>
                <a:srgbClr val="FFFFFF"/>
              </a:solidFill>
            </a:rPr>
            <a:t>DNAm</a:t>
          </a:r>
          <a:r>
            <a:rPr lang="en-US" sz="2600" kern="1200" dirty="0" smtClean="0">
              <a:solidFill>
                <a:srgbClr val="FFFFFF"/>
              </a:solidFill>
            </a:rPr>
            <a:t> signature</a:t>
          </a:r>
          <a:endParaRPr lang="en-US" sz="2600" kern="1200" dirty="0">
            <a:solidFill>
              <a:srgbClr val="FFFFFF"/>
            </a:solidFill>
          </a:endParaRPr>
        </a:p>
      </dsp:txBody>
      <dsp:txXfrm rot="-5400000">
        <a:off x="513580" y="2040680"/>
        <a:ext cx="2978510" cy="493838"/>
      </dsp:txXfrm>
    </dsp:sp>
    <dsp:sp modelId="{04544CC2-E062-C643-A839-1D9EC07980D4}">
      <dsp:nvSpPr>
        <dsp:cNvPr id="0" name=""/>
        <dsp:cNvSpPr/>
      </dsp:nvSpPr>
      <dsp:spPr>
        <a:xfrm rot="5400000">
          <a:off x="5808531" y="-1503629"/>
          <a:ext cx="2315799" cy="6363114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70688" tIns="15240" rIns="15240" bIns="15240" numCol="1" spcCol="1270" anchor="ctr" anchorCtr="0">
          <a:noAutofit/>
        </a:bodyPr>
        <a:lstStyle/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2400" kern="1200" dirty="0" smtClean="0"/>
            <a:t>Identify significant differentially methylated </a:t>
          </a:r>
          <a:r>
            <a:rPr lang="en-US" sz="2400" kern="1200" dirty="0" err="1" smtClean="0"/>
            <a:t>CpG</a:t>
          </a:r>
          <a:r>
            <a:rPr lang="en-US" sz="2400" kern="1200" dirty="0" smtClean="0"/>
            <a:t> sites</a:t>
          </a:r>
          <a:endParaRPr lang="en-US" sz="2400" kern="1200" dirty="0"/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2400" kern="1200" dirty="0" err="1" smtClean="0"/>
            <a:t>Limma</a:t>
          </a:r>
          <a:r>
            <a:rPr lang="en-US" sz="2400" kern="1200" dirty="0" smtClean="0"/>
            <a:t> </a:t>
          </a:r>
          <a:r>
            <a:rPr lang="en-US" sz="2400" kern="1200" dirty="0"/>
            <a:t>regression </a:t>
          </a:r>
          <a:r>
            <a:rPr lang="en-US" sz="2400" kern="1200" dirty="0" smtClean="0"/>
            <a:t>models with covariates</a:t>
          </a:r>
          <a:endParaRPr lang="en-US" sz="2400" kern="1200" dirty="0"/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2400" kern="1200" dirty="0" smtClean="0"/>
            <a:t>Mann</a:t>
          </a:r>
          <a:r>
            <a:rPr lang="en-US" sz="2400" kern="1200" dirty="0"/>
            <a:t>-Whitney U non-parametric </a:t>
          </a:r>
          <a:r>
            <a:rPr lang="en-US" sz="2400" kern="1200" dirty="0" smtClean="0"/>
            <a:t>tests</a:t>
          </a:r>
          <a:endParaRPr lang="en-US" sz="2400" kern="1200" dirty="0"/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2400" kern="1200" dirty="0" smtClean="0"/>
            <a:t>Multiple </a:t>
          </a:r>
          <a:r>
            <a:rPr lang="en-US" sz="2400" kern="1200" dirty="0"/>
            <a:t>testing correction: FDR q &lt; </a:t>
          </a:r>
          <a:r>
            <a:rPr lang="en-US" sz="2400" kern="1200" dirty="0" smtClean="0"/>
            <a:t>0.05; effect size threshold: |</a:t>
          </a:r>
          <a:r>
            <a:rPr lang="en-US" sz="2400" kern="1200" dirty="0" err="1" smtClean="0"/>
            <a:t>Δ</a:t>
          </a:r>
          <a:r>
            <a:rPr lang="en-US" sz="2400" kern="1200" dirty="0" smtClean="0"/>
            <a:t>β|&gt;5%</a:t>
          </a:r>
          <a:endParaRPr lang="en-US" sz="2400" kern="1200" dirty="0"/>
        </a:p>
      </dsp:txBody>
      <dsp:txXfrm rot="-5400000">
        <a:off x="3784874" y="633076"/>
        <a:ext cx="6250066" cy="2089703"/>
      </dsp:txXfrm>
    </dsp:sp>
    <dsp:sp modelId="{FAF63370-BCBC-9E40-B28D-8E52ACD4E1CA}">
      <dsp:nvSpPr>
        <dsp:cNvPr id="0" name=""/>
        <dsp:cNvSpPr/>
      </dsp:nvSpPr>
      <dsp:spPr>
        <a:xfrm rot="5400000">
          <a:off x="161479" y="3641838"/>
          <a:ext cx="3710933" cy="2921949"/>
        </a:xfrm>
        <a:prstGeom prst="chevron">
          <a:avLst/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51000"/>
                <a:satMod val="130000"/>
              </a:schemeClr>
            </a:gs>
            <a:gs pos="80000">
              <a:schemeClr val="accent1">
                <a:hueOff val="0"/>
                <a:satOff val="0"/>
                <a:lumOff val="0"/>
                <a:alphaOff val="0"/>
                <a:shade val="93000"/>
                <a:satMod val="13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shade val="94000"/>
                <a:satMod val="135000"/>
              </a:schemeClr>
            </a:gs>
          </a:gsLst>
          <a:lin ang="16200000" scaled="0"/>
        </a:gra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1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16510" tIns="16510" rIns="16510" bIns="16510" numCol="1" spcCol="1270" anchor="ctr" anchorCtr="0">
          <a:noAutofit/>
        </a:bodyPr>
        <a:lstStyle/>
        <a:p>
          <a:pPr lvl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600" kern="1200" dirty="0" smtClean="0">
              <a:solidFill>
                <a:srgbClr val="FFFFFF"/>
              </a:solidFill>
            </a:rPr>
            <a:t>Validate signature for classification</a:t>
          </a:r>
          <a:endParaRPr lang="en-US" sz="2600" kern="1200" dirty="0">
            <a:solidFill>
              <a:srgbClr val="FFFFFF"/>
            </a:solidFill>
          </a:endParaRPr>
        </a:p>
      </dsp:txBody>
      <dsp:txXfrm rot="-5400000">
        <a:off x="555972" y="4708321"/>
        <a:ext cx="2921949" cy="788984"/>
      </dsp:txXfrm>
    </dsp:sp>
    <dsp:sp modelId="{EB66F9E8-C6DB-AA4C-BE42-2B6D51C1517B}">
      <dsp:nvSpPr>
        <dsp:cNvPr id="0" name=""/>
        <dsp:cNvSpPr/>
      </dsp:nvSpPr>
      <dsp:spPr>
        <a:xfrm rot="5400000">
          <a:off x="6207899" y="876944"/>
          <a:ext cx="2070550" cy="6923754"/>
        </a:xfrm>
        <a:prstGeom prst="round2Same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70688" tIns="15240" rIns="15240" bIns="15240" numCol="1" spcCol="1270" anchor="ctr" anchorCtr="0">
          <a:noAutofit/>
        </a:bodyPr>
        <a:lstStyle/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2400" kern="1200" dirty="0" smtClean="0">
              <a:solidFill>
                <a:srgbClr val="000000"/>
              </a:solidFill>
            </a:rPr>
            <a:t>Blood cell-type comparison</a:t>
          </a:r>
          <a:endParaRPr lang="en-US" sz="2400" kern="1200" dirty="0"/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2400" kern="1200" dirty="0" smtClean="0"/>
            <a:t>Use signatures to build models for classification </a:t>
          </a:r>
          <a:r>
            <a:rPr lang="en-US" sz="2400" kern="1200" dirty="0" smtClean="0">
              <a:solidFill>
                <a:srgbClr val="000000"/>
              </a:solidFill>
            </a:rPr>
            <a:t>of variants/test cases/independent controls [GEO] (sensitivity/specificity)</a:t>
          </a:r>
          <a:endParaRPr lang="en-US" sz="2400" kern="1200" dirty="0"/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2400" kern="1200" dirty="0" smtClean="0">
              <a:solidFill>
                <a:srgbClr val="000000"/>
              </a:solidFill>
            </a:rPr>
            <a:t>Pathway enrichment analysis of signatures</a:t>
          </a:r>
          <a:endParaRPr lang="en-US" sz="2400" kern="1200" dirty="0">
            <a:solidFill>
              <a:srgbClr val="000000"/>
            </a:solidFill>
          </a:endParaRPr>
        </a:p>
      </dsp:txBody>
      <dsp:txXfrm rot="-5400000">
        <a:off x="3781297" y="3404622"/>
        <a:ext cx="6822678" cy="1868398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chevron2">
  <dgm:title val=""/>
  <dgm:desc val=""/>
  <dgm:catLst>
    <dgm:cat type="process" pri="12000"/>
    <dgm:cat type="list" pri="16000"/>
    <dgm:cat type="convert" pri="1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</dgm:ptLst>
      <dgm:cxnLst>
        <dgm:cxn modelId="4" srcId="0" destId="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linearFlow">
    <dgm:varLst>
      <dgm:dir/>
      <dgm:animLvl val="lvl"/>
      <dgm:resizeHandles val="exact"/>
    </dgm:varLst>
    <dgm:alg type="lin">
      <dgm:param type="linDir" val="fromT"/>
      <dgm:param type="nodeHorzAlign" val="l"/>
    </dgm:alg>
    <dgm:shape xmlns:r="http://schemas.openxmlformats.org/officeDocument/2006/relationships" r:blip="">
      <dgm:adjLst/>
    </dgm:shape>
    <dgm:presOf/>
    <dgm:constrLst>
      <dgm:constr type="h" for="ch" forName="composite" refType="h"/>
      <dgm:constr type="w" for="ch" forName="composite" refType="w"/>
      <dgm:constr type="h" for="des" forName="parentText" op="equ"/>
      <dgm:constr type="h" for="ch" forName="sp" val="-14.88"/>
      <dgm:constr type="h" for="ch" forName="sp" refType="w" refFor="des" refForName="parentText" op="gte" fact="-0.3"/>
      <dgm:constr type="primFontSz" for="des" forName="parentText" op="equ" val="65"/>
      <dgm:constr type="primFontSz" for="des" forName="descendantText" op="equ" val="65"/>
    </dgm:constrLst>
    <dgm:ruleLst/>
    <dgm:forEach name="Name0" axis="ch" ptType="node">
      <dgm:layoutNode name="composite">
        <dgm:alg type="composite"/>
        <dgm:shape xmlns:r="http://schemas.openxmlformats.org/officeDocument/2006/relationships" r:blip="">
          <dgm:adjLst/>
        </dgm:shape>
        <dgm:presOf/>
        <dgm:choose name="Name1">
          <dgm:if name="Name2" func="var" arg="dir" op="equ" val="norm">
            <dgm:constrLst>
              <dgm:constr type="t" for="ch" forName="parentText"/>
              <dgm:constr type="l" for="ch" forName="parentText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 refType="w" refFor="ch" refForName="pare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if>
          <dgm:else name="Name3">
            <dgm:constrLst>
              <dgm:constr type="t" for="ch" forName="parentText"/>
              <dgm:constr type="r" for="ch" forName="parentText" refType="w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else>
        </dgm:choose>
        <dgm:ruleLst/>
        <dgm:layoutNode name="parentText" styleLbl="alignNode1">
          <dgm:varLst>
            <dgm:chMax val="1"/>
            <dgm:bulletEnabled val="1"/>
          </dgm:varLst>
          <dgm:alg type="tx"/>
          <dgm:shape xmlns:r="http://schemas.openxmlformats.org/officeDocument/2006/relationships" rot="90" type="chevron" r:blip="">
            <dgm:adjLst/>
          </dgm:shape>
          <dgm:presOf axis="self" ptType="node"/>
          <dgm:constrLst>
            <dgm:constr type="lMarg" refType="primFontSz" fact="0.05"/>
            <dgm:constr type="rMarg" refType="primFontSz" fact="0.05"/>
            <dgm:constr type="tMarg" refType="primFontSz" fact="0.05"/>
            <dgm:constr type="bMarg" refType="primFontSz" fact="0.05"/>
          </dgm:constrLst>
          <dgm:ruleLst>
            <dgm:rule type="h" val="100" fact="NaN" max="NaN"/>
            <dgm:rule type="primFontSz" val="24" fact="NaN" max="NaN"/>
            <dgm:rule type="h" val="110" fact="NaN" max="NaN"/>
            <dgm:rule type="primFontSz" val="18" fact="NaN" max="NaN"/>
            <dgm:rule type="h" val="INF" fact="NaN" max="NaN"/>
            <dgm:rule type="primFontSz" val="5" fact="NaN" max="NaN"/>
          </dgm:ruleLst>
        </dgm:layoutNode>
        <dgm:layoutNode name="descendantText" styleLbl="alignAcc1">
          <dgm:varLst>
            <dgm:bulletEnabled val="1"/>
          </dgm:varLst>
          <dgm:choose name="Name4">
            <dgm:if name="Name5" func="var" arg="dir" op="equ" val="norm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90" type="round2SameRect" r:blip="">
                <dgm:adjLst/>
              </dgm:shape>
            </dgm:if>
            <dgm:else name="Name6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-90" type="round2SameRect" r:blip="">
                <dgm:adjLst/>
              </dgm:shape>
            </dgm:else>
          </dgm:choose>
          <dgm:presOf axis="des" ptType="node"/>
          <dgm:choose name="Name7">
            <dgm:if name="Name8" func="var" arg="dir" op="equ" val="norm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rMarg" refType="primFontSz" fact="0.05"/>
              </dgm:constrLst>
            </dgm:if>
            <dgm:else name="Name9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lMarg" refType="primFontSz" fact="0.05"/>
              </dgm:constrLst>
            </dgm:else>
          </dgm:choose>
          <dgm:ruleLst>
            <dgm:rule type="primFontSz" val="5" fact="NaN" max="NaN"/>
          </dgm:ruleLst>
        </dgm:layoutNode>
      </dgm:layoutNode>
      <dgm:forEach name="Name10" axis="followSib" ptType="sibTrans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>
            <dgm:constr type="w" val="1"/>
            <dgm:constr type="h" val="37.5"/>
          </dgm:constrLst>
          <dgm:ruleLst/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chevron2">
  <dgm:title val=""/>
  <dgm:desc val=""/>
  <dgm:catLst>
    <dgm:cat type="process" pri="12000"/>
    <dgm:cat type="list" pri="16000"/>
    <dgm:cat type="convert" pri="1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</dgm:ptLst>
      <dgm:cxnLst>
        <dgm:cxn modelId="4" srcId="0" destId="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linearFlow">
    <dgm:varLst>
      <dgm:dir/>
      <dgm:animLvl val="lvl"/>
      <dgm:resizeHandles val="exact"/>
    </dgm:varLst>
    <dgm:alg type="lin">
      <dgm:param type="linDir" val="fromT"/>
      <dgm:param type="nodeHorzAlign" val="l"/>
    </dgm:alg>
    <dgm:shape xmlns:r="http://schemas.openxmlformats.org/officeDocument/2006/relationships" r:blip="">
      <dgm:adjLst/>
    </dgm:shape>
    <dgm:presOf/>
    <dgm:constrLst>
      <dgm:constr type="h" for="ch" forName="composite" refType="h"/>
      <dgm:constr type="w" for="ch" forName="composite" refType="w"/>
      <dgm:constr type="h" for="des" forName="parentText" op="equ"/>
      <dgm:constr type="h" for="ch" forName="sp" val="-14.88"/>
      <dgm:constr type="h" for="ch" forName="sp" refType="w" refFor="des" refForName="parentText" op="gte" fact="-0.3"/>
      <dgm:constr type="primFontSz" for="des" forName="parentText" op="equ" val="65"/>
      <dgm:constr type="primFontSz" for="des" forName="descendantText" op="equ" val="65"/>
    </dgm:constrLst>
    <dgm:ruleLst/>
    <dgm:forEach name="Name0" axis="ch" ptType="node">
      <dgm:layoutNode name="composite">
        <dgm:alg type="composite"/>
        <dgm:shape xmlns:r="http://schemas.openxmlformats.org/officeDocument/2006/relationships" r:blip="">
          <dgm:adjLst/>
        </dgm:shape>
        <dgm:presOf/>
        <dgm:choose name="Name1">
          <dgm:if name="Name2" func="var" arg="dir" op="equ" val="norm">
            <dgm:constrLst>
              <dgm:constr type="t" for="ch" forName="parentText"/>
              <dgm:constr type="l" for="ch" forName="parentText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 refType="w" refFor="ch" refForName="pare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if>
          <dgm:else name="Name3">
            <dgm:constrLst>
              <dgm:constr type="t" for="ch" forName="parentText"/>
              <dgm:constr type="r" for="ch" forName="parentText" refType="w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else>
        </dgm:choose>
        <dgm:ruleLst/>
        <dgm:layoutNode name="parentText" styleLbl="alignNode1">
          <dgm:varLst>
            <dgm:chMax val="1"/>
            <dgm:bulletEnabled val="1"/>
          </dgm:varLst>
          <dgm:alg type="tx"/>
          <dgm:shape xmlns:r="http://schemas.openxmlformats.org/officeDocument/2006/relationships" rot="90" type="chevron" r:blip="">
            <dgm:adjLst/>
          </dgm:shape>
          <dgm:presOf axis="self" ptType="node"/>
          <dgm:constrLst>
            <dgm:constr type="lMarg" refType="primFontSz" fact="0.05"/>
            <dgm:constr type="rMarg" refType="primFontSz" fact="0.05"/>
            <dgm:constr type="tMarg" refType="primFontSz" fact="0.05"/>
            <dgm:constr type="bMarg" refType="primFontSz" fact="0.05"/>
          </dgm:constrLst>
          <dgm:ruleLst>
            <dgm:rule type="h" val="100" fact="NaN" max="NaN"/>
            <dgm:rule type="primFontSz" val="24" fact="NaN" max="NaN"/>
            <dgm:rule type="h" val="110" fact="NaN" max="NaN"/>
            <dgm:rule type="primFontSz" val="18" fact="NaN" max="NaN"/>
            <dgm:rule type="h" val="INF" fact="NaN" max="NaN"/>
            <dgm:rule type="primFontSz" val="5" fact="NaN" max="NaN"/>
          </dgm:ruleLst>
        </dgm:layoutNode>
        <dgm:layoutNode name="descendantText" styleLbl="alignAcc1">
          <dgm:varLst>
            <dgm:bulletEnabled val="1"/>
          </dgm:varLst>
          <dgm:choose name="Name4">
            <dgm:if name="Name5" func="var" arg="dir" op="equ" val="norm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90" type="round2SameRect" r:blip="">
                <dgm:adjLst/>
              </dgm:shape>
            </dgm:if>
            <dgm:else name="Name6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-90" type="round2SameRect" r:blip="">
                <dgm:adjLst/>
              </dgm:shape>
            </dgm:else>
          </dgm:choose>
          <dgm:presOf axis="des" ptType="node"/>
          <dgm:choose name="Name7">
            <dgm:if name="Name8" func="var" arg="dir" op="equ" val="norm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rMarg" refType="primFontSz" fact="0.05"/>
              </dgm:constrLst>
            </dgm:if>
            <dgm:else name="Name9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lMarg" refType="primFontSz" fact="0.05"/>
              </dgm:constrLst>
            </dgm:else>
          </dgm:choose>
          <dgm:ruleLst>
            <dgm:rule type="primFontSz" val="5" fact="NaN" max="NaN"/>
          </dgm:ruleLst>
        </dgm:layoutNode>
      </dgm:layoutNode>
      <dgm:forEach name="Name10" axis="followSib" ptType="sibTrans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>
            <dgm:constr type="w" val="1"/>
            <dgm:constr type="h" val="37.5"/>
          </dgm:constrLst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CAA9A1E-B63F-46CE-8881-90E2875BDC13}" type="datetimeFigureOut">
              <a:rPr lang="en-CA" smtClean="0"/>
              <a:t>19-02-07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73163" y="685800"/>
            <a:ext cx="45116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C56CE4-BC0F-4C65-BBB5-562343268DD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339817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809332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904664" algn="l" defTabSz="1809332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809332" algn="l" defTabSz="1809332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2713999" algn="l" defTabSz="1809332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3618663" algn="l" defTabSz="1809332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4523327" algn="l" defTabSz="1809332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5427993" algn="l" defTabSz="1809332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6332659" algn="l" defTabSz="1809332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7237323" algn="l" defTabSz="1809332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dirty="0" smtClean="0"/>
              <a:t>Supplemental Figure 1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BB07637-68C3-8D42-9941-6B11E06FB71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73711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73163" y="685800"/>
            <a:ext cx="451167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dirty="0" smtClean="0"/>
              <a:t>Supplemental Figure 1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056F25B-B6CB-8A4E-874E-ECD9D04F756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8816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73163" y="685800"/>
            <a:ext cx="451167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dirty="0" smtClean="0"/>
              <a:t>Supplemental Figure 2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056F25B-B6CB-8A4E-874E-ECD9D04F756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88163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73163" y="685800"/>
            <a:ext cx="451167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181042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2400" b="1" dirty="0" smtClean="0"/>
              <a:t>Figure S4. Differentially methylated regions overlapping differentially methylated </a:t>
            </a:r>
            <a:r>
              <a:rPr lang="en-US" sz="2400" b="1" dirty="0" err="1" smtClean="0"/>
              <a:t>CpG</a:t>
            </a:r>
            <a:r>
              <a:rPr lang="en-US" sz="2400" b="1" dirty="0" smtClean="0"/>
              <a:t> sites in the 16p11.2del and CHD8</a:t>
            </a:r>
            <a:r>
              <a:rPr lang="en-US" sz="2400" b="1" baseline="30000" dirty="0" smtClean="0"/>
              <a:t>+/-</a:t>
            </a:r>
            <a:r>
              <a:rPr lang="en-US" sz="2400" b="1" dirty="0" smtClean="0"/>
              <a:t> </a:t>
            </a:r>
            <a:r>
              <a:rPr lang="en-US" sz="2400" b="1" dirty="0" err="1" smtClean="0"/>
              <a:t>DNAm</a:t>
            </a:r>
            <a:r>
              <a:rPr lang="en-US" sz="2400" b="1" dirty="0" smtClean="0"/>
              <a:t> signatures.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C56CE4-BC0F-4C65-BBB5-562343268DD3}" type="slidenum">
              <a:rPr lang="en-CA" smtClean="0"/>
              <a:t>4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4867949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C56CE4-BC0F-4C65-BBB5-562343268DD3}" type="slidenum">
              <a:rPr lang="en-CA" smtClean="0"/>
              <a:t>8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206300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292" y="4249508"/>
            <a:ext cx="15303262" cy="293222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700579" y="7751712"/>
            <a:ext cx="12602687" cy="34958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9046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8093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7139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6186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5233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4279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3326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72373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B532E-0337-4613-820B-7F74CF9BCE37}" type="datetimeFigureOut">
              <a:rPr lang="en-CA" smtClean="0"/>
              <a:t>19-02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32454-10C8-4C58-9A00-0AF529CDB3E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732934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B532E-0337-4613-820B-7F74CF9BCE37}" type="datetimeFigureOut">
              <a:rPr lang="en-CA" smtClean="0"/>
              <a:t>19-02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32454-10C8-4C58-9A00-0AF529CDB3E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54912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52782" y="547815"/>
            <a:ext cx="4050864" cy="1167189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00196" y="547815"/>
            <a:ext cx="11852527" cy="1167189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B532E-0337-4613-820B-7F74CF9BCE37}" type="datetimeFigureOut">
              <a:rPr lang="en-CA" smtClean="0"/>
              <a:t>19-02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32454-10C8-4C58-9A00-0AF529CDB3E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43102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B532E-0337-4613-820B-7F74CF9BCE37}" type="datetimeFigureOut">
              <a:rPr lang="en-CA" smtClean="0"/>
              <a:t>19-02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32454-10C8-4C58-9A00-0AF529CDB3E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941532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22181" y="8790347"/>
            <a:ext cx="15303262" cy="2716898"/>
          </a:xfrm>
        </p:spPr>
        <p:txBody>
          <a:bodyPr anchor="t"/>
          <a:lstStyle>
            <a:lvl1pPr algn="l">
              <a:defRPr sz="79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22181" y="5797960"/>
            <a:ext cx="15303262" cy="2992387"/>
          </a:xfrm>
        </p:spPr>
        <p:txBody>
          <a:bodyPr anchor="b"/>
          <a:lstStyle>
            <a:lvl1pPr marL="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1pPr>
            <a:lvl2pPr marL="904664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2pPr>
            <a:lvl3pPr marL="1809332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713999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4pPr>
            <a:lvl5pPr marL="3618663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5pPr>
            <a:lvl6pPr marL="4523327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6pPr>
            <a:lvl7pPr marL="5427993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7pPr>
            <a:lvl8pPr marL="6332659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8pPr>
            <a:lvl9pPr marL="7237323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B532E-0337-4613-820B-7F74CF9BCE37}" type="datetimeFigureOut">
              <a:rPr lang="en-CA" smtClean="0"/>
              <a:t>19-02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32454-10C8-4C58-9A00-0AF529CDB3E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478446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00194" y="3191881"/>
            <a:ext cx="7951695" cy="9027830"/>
          </a:xfrm>
        </p:spPr>
        <p:txBody>
          <a:bodyPr/>
          <a:lstStyle>
            <a:lvl1pPr>
              <a:defRPr sz="5500"/>
            </a:lvl1pPr>
            <a:lvl2pPr>
              <a:defRPr sz="4800"/>
            </a:lvl2pPr>
            <a:lvl3pPr>
              <a:defRPr sz="40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51951" y="3191881"/>
            <a:ext cx="7951695" cy="9027830"/>
          </a:xfrm>
        </p:spPr>
        <p:txBody>
          <a:bodyPr/>
          <a:lstStyle>
            <a:lvl1pPr>
              <a:defRPr sz="5500"/>
            </a:lvl1pPr>
            <a:lvl2pPr>
              <a:defRPr sz="4800"/>
            </a:lvl2pPr>
            <a:lvl3pPr>
              <a:defRPr sz="40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B532E-0337-4613-820B-7F74CF9BCE37}" type="datetimeFigureOut">
              <a:rPr lang="en-CA" smtClean="0"/>
              <a:t>19-02-0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32454-10C8-4C58-9A00-0AF529CDB3E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93255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0192" y="3062053"/>
            <a:ext cx="7954822" cy="1276118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04664" indent="0">
              <a:buNone/>
              <a:defRPr sz="4000" b="1"/>
            </a:lvl2pPr>
            <a:lvl3pPr marL="1809332" indent="0">
              <a:buNone/>
              <a:defRPr sz="3600" b="1"/>
            </a:lvl3pPr>
            <a:lvl4pPr marL="2713999" indent="0">
              <a:buNone/>
              <a:defRPr sz="3200" b="1"/>
            </a:lvl4pPr>
            <a:lvl5pPr marL="3618663" indent="0">
              <a:buNone/>
              <a:defRPr sz="3200" b="1"/>
            </a:lvl5pPr>
            <a:lvl6pPr marL="4523327" indent="0">
              <a:buNone/>
              <a:defRPr sz="3200" b="1"/>
            </a:lvl6pPr>
            <a:lvl7pPr marL="5427993" indent="0">
              <a:buNone/>
              <a:defRPr sz="3200" b="1"/>
            </a:lvl7pPr>
            <a:lvl8pPr marL="6332659" indent="0">
              <a:buNone/>
              <a:defRPr sz="3200" b="1"/>
            </a:lvl8pPr>
            <a:lvl9pPr marL="7237323" indent="0">
              <a:buNone/>
              <a:defRPr sz="3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00192" y="4338173"/>
            <a:ext cx="7954822" cy="7881539"/>
          </a:xfrm>
        </p:spPr>
        <p:txBody>
          <a:bodyPr/>
          <a:lstStyle>
            <a:lvl1pPr>
              <a:defRPr sz="4800"/>
            </a:lvl1pPr>
            <a:lvl2pPr>
              <a:defRPr sz="4000"/>
            </a:lvl2pPr>
            <a:lvl3pPr>
              <a:defRPr sz="36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45711" y="3062053"/>
            <a:ext cx="7957946" cy="1276118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04664" indent="0">
              <a:buNone/>
              <a:defRPr sz="4000" b="1"/>
            </a:lvl2pPr>
            <a:lvl3pPr marL="1809332" indent="0">
              <a:buNone/>
              <a:defRPr sz="3600" b="1"/>
            </a:lvl3pPr>
            <a:lvl4pPr marL="2713999" indent="0">
              <a:buNone/>
              <a:defRPr sz="3200" b="1"/>
            </a:lvl4pPr>
            <a:lvl5pPr marL="3618663" indent="0">
              <a:buNone/>
              <a:defRPr sz="3200" b="1"/>
            </a:lvl5pPr>
            <a:lvl6pPr marL="4523327" indent="0">
              <a:buNone/>
              <a:defRPr sz="3200" b="1"/>
            </a:lvl6pPr>
            <a:lvl7pPr marL="5427993" indent="0">
              <a:buNone/>
              <a:defRPr sz="3200" b="1"/>
            </a:lvl7pPr>
            <a:lvl8pPr marL="6332659" indent="0">
              <a:buNone/>
              <a:defRPr sz="3200" b="1"/>
            </a:lvl8pPr>
            <a:lvl9pPr marL="7237323" indent="0">
              <a:buNone/>
              <a:defRPr sz="3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45711" y="4338173"/>
            <a:ext cx="7957946" cy="7881539"/>
          </a:xfrm>
        </p:spPr>
        <p:txBody>
          <a:bodyPr/>
          <a:lstStyle>
            <a:lvl1pPr>
              <a:defRPr sz="4800"/>
            </a:lvl1pPr>
            <a:lvl2pPr>
              <a:defRPr sz="4000"/>
            </a:lvl2pPr>
            <a:lvl3pPr>
              <a:defRPr sz="36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B532E-0337-4613-820B-7F74CF9BCE37}" type="datetimeFigureOut">
              <a:rPr lang="en-CA" smtClean="0"/>
              <a:t>19-02-0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32454-10C8-4C58-9A00-0AF529CDB3E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90980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B532E-0337-4613-820B-7F74CF9BCE37}" type="datetimeFigureOut">
              <a:rPr lang="en-CA" smtClean="0"/>
              <a:t>19-02-0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32454-10C8-4C58-9A00-0AF529CDB3E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23856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B532E-0337-4613-820B-7F74CF9BCE37}" type="datetimeFigureOut">
              <a:rPr lang="en-CA" smtClean="0"/>
              <a:t>19-02-0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32454-10C8-4C58-9A00-0AF529CDB3E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58739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0192" y="544648"/>
            <a:ext cx="5923141" cy="2317913"/>
          </a:xfrm>
        </p:spPr>
        <p:txBody>
          <a:bodyPr anchor="b"/>
          <a:lstStyle>
            <a:lvl1pPr algn="l">
              <a:defRPr sz="4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038998" y="544647"/>
            <a:ext cx="10064646" cy="11675064"/>
          </a:xfrm>
        </p:spPr>
        <p:txBody>
          <a:bodyPr/>
          <a:lstStyle>
            <a:lvl1pPr>
              <a:defRPr sz="6300"/>
            </a:lvl1pPr>
            <a:lvl2pPr>
              <a:defRPr sz="55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0192" y="2862570"/>
            <a:ext cx="5923141" cy="9357151"/>
          </a:xfrm>
        </p:spPr>
        <p:txBody>
          <a:bodyPr/>
          <a:lstStyle>
            <a:lvl1pPr marL="0" indent="0">
              <a:buNone/>
              <a:defRPr sz="2800"/>
            </a:lvl1pPr>
            <a:lvl2pPr marL="904664" indent="0">
              <a:buNone/>
              <a:defRPr sz="2400"/>
            </a:lvl2pPr>
            <a:lvl3pPr marL="1809332" indent="0">
              <a:buNone/>
              <a:defRPr sz="2000"/>
            </a:lvl3pPr>
            <a:lvl4pPr marL="2713999" indent="0">
              <a:buNone/>
              <a:defRPr sz="1800"/>
            </a:lvl4pPr>
            <a:lvl5pPr marL="3618663" indent="0">
              <a:buNone/>
              <a:defRPr sz="1800"/>
            </a:lvl5pPr>
            <a:lvl6pPr marL="4523327" indent="0">
              <a:buNone/>
              <a:defRPr sz="1800"/>
            </a:lvl6pPr>
            <a:lvl7pPr marL="5427993" indent="0">
              <a:buNone/>
              <a:defRPr sz="1800"/>
            </a:lvl7pPr>
            <a:lvl8pPr marL="6332659" indent="0">
              <a:buNone/>
              <a:defRPr sz="1800"/>
            </a:lvl8pPr>
            <a:lvl9pPr marL="7237323" indent="0">
              <a:buNone/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B532E-0337-4613-820B-7F74CF9BCE37}" type="datetimeFigureOut">
              <a:rPr lang="en-CA" smtClean="0"/>
              <a:t>19-02-0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32454-10C8-4C58-9A00-0AF529CDB3E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674101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8882" y="9575643"/>
            <a:ext cx="10802303" cy="1130459"/>
          </a:xfrm>
        </p:spPr>
        <p:txBody>
          <a:bodyPr anchor="b"/>
          <a:lstStyle>
            <a:lvl1pPr algn="l">
              <a:defRPr sz="4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528882" y="1222289"/>
            <a:ext cx="10802303" cy="8207693"/>
          </a:xfrm>
        </p:spPr>
        <p:txBody>
          <a:bodyPr/>
          <a:lstStyle>
            <a:lvl1pPr marL="0" indent="0">
              <a:buNone/>
              <a:defRPr sz="6300"/>
            </a:lvl1pPr>
            <a:lvl2pPr marL="904664" indent="0">
              <a:buNone/>
              <a:defRPr sz="5500"/>
            </a:lvl2pPr>
            <a:lvl3pPr marL="1809332" indent="0">
              <a:buNone/>
              <a:defRPr sz="4800"/>
            </a:lvl3pPr>
            <a:lvl4pPr marL="2713999" indent="0">
              <a:buNone/>
              <a:defRPr sz="4000"/>
            </a:lvl4pPr>
            <a:lvl5pPr marL="3618663" indent="0">
              <a:buNone/>
              <a:defRPr sz="4000"/>
            </a:lvl5pPr>
            <a:lvl6pPr marL="4523327" indent="0">
              <a:buNone/>
              <a:defRPr sz="4000"/>
            </a:lvl6pPr>
            <a:lvl7pPr marL="5427993" indent="0">
              <a:buNone/>
              <a:defRPr sz="4000"/>
            </a:lvl7pPr>
            <a:lvl8pPr marL="6332659" indent="0">
              <a:buNone/>
              <a:defRPr sz="4000"/>
            </a:lvl8pPr>
            <a:lvl9pPr marL="7237323" indent="0">
              <a:buNone/>
              <a:defRPr sz="4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28882" y="10706102"/>
            <a:ext cx="10802303" cy="1605439"/>
          </a:xfrm>
        </p:spPr>
        <p:txBody>
          <a:bodyPr/>
          <a:lstStyle>
            <a:lvl1pPr marL="0" indent="0">
              <a:buNone/>
              <a:defRPr sz="2800"/>
            </a:lvl1pPr>
            <a:lvl2pPr marL="904664" indent="0">
              <a:buNone/>
              <a:defRPr sz="2400"/>
            </a:lvl2pPr>
            <a:lvl3pPr marL="1809332" indent="0">
              <a:buNone/>
              <a:defRPr sz="2000"/>
            </a:lvl3pPr>
            <a:lvl4pPr marL="2713999" indent="0">
              <a:buNone/>
              <a:defRPr sz="1800"/>
            </a:lvl4pPr>
            <a:lvl5pPr marL="3618663" indent="0">
              <a:buNone/>
              <a:defRPr sz="1800"/>
            </a:lvl5pPr>
            <a:lvl6pPr marL="4523327" indent="0">
              <a:buNone/>
              <a:defRPr sz="1800"/>
            </a:lvl6pPr>
            <a:lvl7pPr marL="5427993" indent="0">
              <a:buNone/>
              <a:defRPr sz="1800"/>
            </a:lvl7pPr>
            <a:lvl8pPr marL="6332659" indent="0">
              <a:buNone/>
              <a:defRPr sz="1800"/>
            </a:lvl8pPr>
            <a:lvl9pPr marL="7237323" indent="0">
              <a:buNone/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B532E-0337-4613-820B-7F74CF9BCE37}" type="datetimeFigureOut">
              <a:rPr lang="en-CA" smtClean="0"/>
              <a:t>19-02-0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32454-10C8-4C58-9A00-0AF529CDB3E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191360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00194" y="547814"/>
            <a:ext cx="16203454" cy="2279915"/>
          </a:xfrm>
          <a:prstGeom prst="rect">
            <a:avLst/>
          </a:prstGeom>
        </p:spPr>
        <p:txBody>
          <a:bodyPr vert="horz" lIns="180931" tIns="90466" rIns="180931" bIns="90466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0194" y="3191881"/>
            <a:ext cx="16203454" cy="9027830"/>
          </a:xfrm>
          <a:prstGeom prst="rect">
            <a:avLst/>
          </a:prstGeom>
        </p:spPr>
        <p:txBody>
          <a:bodyPr vert="horz" lIns="180931" tIns="90466" rIns="180931" bIns="90466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00192" y="12678868"/>
            <a:ext cx="4200896" cy="728306"/>
          </a:xfrm>
          <a:prstGeom prst="rect">
            <a:avLst/>
          </a:prstGeom>
        </p:spPr>
        <p:txBody>
          <a:bodyPr vert="horz" lIns="180931" tIns="90466" rIns="180931" bIns="90466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DB532E-0337-4613-820B-7F74CF9BCE37}" type="datetimeFigureOut">
              <a:rPr lang="en-CA" smtClean="0"/>
              <a:t>19-02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151313" y="12678868"/>
            <a:ext cx="5701215" cy="728306"/>
          </a:xfrm>
          <a:prstGeom prst="rect">
            <a:avLst/>
          </a:prstGeom>
        </p:spPr>
        <p:txBody>
          <a:bodyPr vert="horz" lIns="180931" tIns="90466" rIns="180931" bIns="90466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02750" y="12678868"/>
            <a:ext cx="4200896" cy="728306"/>
          </a:xfrm>
          <a:prstGeom prst="rect">
            <a:avLst/>
          </a:prstGeom>
        </p:spPr>
        <p:txBody>
          <a:bodyPr vert="horz" lIns="180931" tIns="90466" rIns="180931" bIns="90466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B32454-10C8-4C58-9A00-0AF529CDB3E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22435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809332" rtl="0" eaLnBrk="1" latinLnBrk="0" hangingPunct="1">
        <a:spcBef>
          <a:spcPct val="0"/>
        </a:spcBef>
        <a:buNone/>
        <a:defRPr sz="8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78504" indent="-678504" algn="l" defTabSz="1809332" rtl="0" eaLnBrk="1" latinLnBrk="0" hangingPunct="1">
        <a:spcBef>
          <a:spcPct val="20000"/>
        </a:spcBef>
        <a:buFont typeface="Arial" pitchFamily="34" charset="0"/>
        <a:buChar char="•"/>
        <a:defRPr sz="6300" kern="1200">
          <a:solidFill>
            <a:schemeClr val="tx1"/>
          </a:solidFill>
          <a:latin typeface="+mn-lt"/>
          <a:ea typeface="+mn-ea"/>
          <a:cs typeface="+mn-cs"/>
        </a:defRPr>
      </a:lvl1pPr>
      <a:lvl2pPr marL="1470080" indent="-565416" algn="l" defTabSz="1809332" rtl="0" eaLnBrk="1" latinLnBrk="0" hangingPunct="1">
        <a:spcBef>
          <a:spcPct val="20000"/>
        </a:spcBef>
        <a:buFont typeface="Arial" pitchFamily="34" charset="0"/>
        <a:buChar char="–"/>
        <a:defRPr sz="5500" kern="1200">
          <a:solidFill>
            <a:schemeClr val="tx1"/>
          </a:solidFill>
          <a:latin typeface="+mn-lt"/>
          <a:ea typeface="+mn-ea"/>
          <a:cs typeface="+mn-cs"/>
        </a:defRPr>
      </a:lvl2pPr>
      <a:lvl3pPr marL="2261664" indent="-452336" algn="l" defTabSz="1809332" rtl="0" eaLnBrk="1" latinLnBrk="0" hangingPunct="1">
        <a:spcBef>
          <a:spcPct val="20000"/>
        </a:spcBef>
        <a:buFont typeface="Arial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3pPr>
      <a:lvl4pPr marL="3166329" indent="-452336" algn="l" defTabSz="1809332" rtl="0" eaLnBrk="1" latinLnBrk="0" hangingPunct="1">
        <a:spcBef>
          <a:spcPct val="20000"/>
        </a:spcBef>
        <a:buFont typeface="Arial" pitchFamily="34" charset="0"/>
        <a:buChar char="–"/>
        <a:defRPr sz="4000" kern="1200">
          <a:solidFill>
            <a:schemeClr val="tx1"/>
          </a:solidFill>
          <a:latin typeface="+mn-lt"/>
          <a:ea typeface="+mn-ea"/>
          <a:cs typeface="+mn-cs"/>
        </a:defRPr>
      </a:lvl4pPr>
      <a:lvl5pPr marL="4070995" indent="-452336" algn="l" defTabSz="1809332" rtl="0" eaLnBrk="1" latinLnBrk="0" hangingPunct="1">
        <a:spcBef>
          <a:spcPct val="20000"/>
        </a:spcBef>
        <a:buFont typeface="Arial" pitchFamily="34" charset="0"/>
        <a:buChar char="»"/>
        <a:defRPr sz="4000" kern="1200">
          <a:solidFill>
            <a:schemeClr val="tx1"/>
          </a:solidFill>
          <a:latin typeface="+mn-lt"/>
          <a:ea typeface="+mn-ea"/>
          <a:cs typeface="+mn-cs"/>
        </a:defRPr>
      </a:lvl5pPr>
      <a:lvl6pPr marL="4975663" indent="-452336" algn="l" defTabSz="1809332" rtl="0" eaLnBrk="1" latinLnBrk="0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6pPr>
      <a:lvl7pPr marL="5880327" indent="-452336" algn="l" defTabSz="1809332" rtl="0" eaLnBrk="1" latinLnBrk="0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7pPr>
      <a:lvl8pPr marL="6784991" indent="-452336" algn="l" defTabSz="1809332" rtl="0" eaLnBrk="1" latinLnBrk="0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8pPr>
      <a:lvl9pPr marL="7689656" indent="-452336" algn="l" defTabSz="1809332" rtl="0" eaLnBrk="1" latinLnBrk="0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9332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04664" algn="l" defTabSz="1809332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09332" algn="l" defTabSz="1809332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13999" algn="l" defTabSz="1809332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18663" algn="l" defTabSz="1809332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23327" algn="l" defTabSz="1809332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27993" algn="l" defTabSz="1809332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332659" algn="l" defTabSz="1809332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237323" algn="l" defTabSz="1809332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diagramColors" Target="../diagrams/colors2.xml"/><Relationship Id="rId12" Type="http://schemas.microsoft.com/office/2007/relationships/diagramDrawing" Target="../diagrams/drawing2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diagramData" Target="../diagrams/data1.xml"/><Relationship Id="rId4" Type="http://schemas.openxmlformats.org/officeDocument/2006/relationships/diagramLayout" Target="../diagrams/layout1.xml"/><Relationship Id="rId5" Type="http://schemas.openxmlformats.org/officeDocument/2006/relationships/diagramQuickStyle" Target="../diagrams/quickStyle1.xml"/><Relationship Id="rId6" Type="http://schemas.openxmlformats.org/officeDocument/2006/relationships/diagramColors" Target="../diagrams/colors1.xml"/><Relationship Id="rId7" Type="http://schemas.microsoft.com/office/2007/relationships/diagramDrawing" Target="../diagrams/drawing1.xml"/><Relationship Id="rId8" Type="http://schemas.openxmlformats.org/officeDocument/2006/relationships/diagramData" Target="../diagrams/data2.xml"/><Relationship Id="rId9" Type="http://schemas.openxmlformats.org/officeDocument/2006/relationships/diagramLayout" Target="../diagrams/layout2.xml"/><Relationship Id="rId10" Type="http://schemas.openxmlformats.org/officeDocument/2006/relationships/diagramQuickStyle" Target="../diagrams/quickStyle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3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1.emf"/><Relationship Id="rId12" Type="http://schemas.openxmlformats.org/officeDocument/2006/relationships/image" Target="../media/image12.emf"/><Relationship Id="rId13" Type="http://schemas.openxmlformats.org/officeDocument/2006/relationships/image" Target="../media/image13.emf"/><Relationship Id="rId14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5.tiff"/><Relationship Id="rId3" Type="http://schemas.openxmlformats.org/officeDocument/2006/relationships/image" Target="../media/image16.tif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7.tiff"/><Relationship Id="rId3" Type="http://schemas.openxmlformats.org/officeDocument/2006/relationships/image" Target="../media/image16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4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8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21.e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77206" y="4084609"/>
            <a:ext cx="3751312" cy="921474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pPr algn="ctr"/>
            <a:r>
              <a:rPr lang="en-US" sz="2400" dirty="0"/>
              <a:t>16p11.2del signature cases</a:t>
            </a:r>
          </a:p>
          <a:p>
            <a:pPr algn="ctr"/>
            <a:r>
              <a:rPr lang="en-US" sz="2400" dirty="0"/>
              <a:t>(n=9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65947" y="5334884"/>
            <a:ext cx="3773855" cy="921474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pPr algn="ctr"/>
            <a:r>
              <a:rPr lang="en-US" sz="2400" dirty="0"/>
              <a:t>Age-, sex-matched controls</a:t>
            </a:r>
          </a:p>
          <a:p>
            <a:pPr algn="ctr"/>
            <a:r>
              <a:rPr lang="en-US" sz="2400" dirty="0"/>
              <a:t>(n=23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56394" y="6445779"/>
            <a:ext cx="3206703" cy="920872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pPr algn="ctr"/>
            <a:r>
              <a:rPr lang="en-US" sz="2400" i="1" dirty="0"/>
              <a:t>CHD8</a:t>
            </a:r>
            <a:r>
              <a:rPr lang="en-US" sz="2400" i="1" baseline="30000" dirty="0"/>
              <a:t>+/-</a:t>
            </a:r>
            <a:r>
              <a:rPr lang="en-US" sz="2400" dirty="0"/>
              <a:t>signature cases</a:t>
            </a:r>
          </a:p>
          <a:p>
            <a:pPr algn="ctr"/>
            <a:r>
              <a:rPr lang="en-US" sz="2400" dirty="0"/>
              <a:t>(n=7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72818" y="7730599"/>
            <a:ext cx="3773855" cy="921474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pPr algn="ctr"/>
            <a:r>
              <a:rPr lang="en-US" sz="2400" dirty="0"/>
              <a:t>Age-, sex-matched controls</a:t>
            </a:r>
          </a:p>
          <a:p>
            <a:pPr algn="ctr"/>
            <a:r>
              <a:rPr lang="en-US" sz="2400" dirty="0"/>
              <a:t>(n=21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79675" y="1708974"/>
            <a:ext cx="3613053" cy="921474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pPr algn="ctr"/>
            <a:r>
              <a:rPr lang="en-US" sz="2400" dirty="0"/>
              <a:t>Heterogeneous ASD cases</a:t>
            </a:r>
          </a:p>
          <a:p>
            <a:pPr algn="ctr"/>
            <a:r>
              <a:rPr lang="en-US" sz="2400" dirty="0"/>
              <a:t>(n=52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99279" y="2986615"/>
            <a:ext cx="3773855" cy="921474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pPr algn="ctr"/>
            <a:r>
              <a:rPr lang="en-US" sz="2400" dirty="0"/>
              <a:t>Age-, sex-matched controls</a:t>
            </a:r>
          </a:p>
          <a:p>
            <a:pPr algn="ctr"/>
            <a:r>
              <a:rPr lang="en-US" sz="2400" dirty="0"/>
              <a:t>(n=30)</a:t>
            </a: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2352872" y="4781366"/>
            <a:ext cx="0" cy="739139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3908985" y="4060700"/>
            <a:ext cx="2826032" cy="1473395"/>
          </a:xfrm>
          <a:prstGeom prst="rect">
            <a:avLst/>
          </a:prstGeom>
          <a:noFill/>
        </p:spPr>
        <p:txBody>
          <a:bodyPr wrap="square" lIns="181042" tIns="90521" rIns="181042" bIns="90521" rtlCol="0">
            <a:spAutoFit/>
          </a:bodyPr>
          <a:lstStyle/>
          <a:p>
            <a:pPr algn="ctr"/>
            <a:r>
              <a:rPr lang="en-US" sz="2800" dirty="0"/>
              <a:t>Blood DNA</a:t>
            </a:r>
          </a:p>
          <a:p>
            <a:pPr algn="ctr"/>
            <a:r>
              <a:rPr lang="en-US" sz="2800" dirty="0"/>
              <a:t>for 450K </a:t>
            </a:r>
          </a:p>
          <a:p>
            <a:pPr algn="ctr"/>
            <a:r>
              <a:rPr lang="en-US" sz="2800" dirty="0" err="1"/>
              <a:t>DNAm</a:t>
            </a:r>
            <a:r>
              <a:rPr lang="en-US" sz="2800" dirty="0"/>
              <a:t> array  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238478" y="952123"/>
            <a:ext cx="2282386" cy="736808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US" b="1" dirty="0" smtClean="0"/>
              <a:t>TRAINING</a:t>
            </a:r>
            <a:endParaRPr lang="en-US" b="1" dirty="0"/>
          </a:p>
        </p:txBody>
      </p:sp>
      <p:sp>
        <p:nvSpPr>
          <p:cNvPr id="32" name="Rounded Rectangle 31"/>
          <p:cNvSpPr/>
          <p:nvPr/>
        </p:nvSpPr>
        <p:spPr>
          <a:xfrm>
            <a:off x="597109" y="1754480"/>
            <a:ext cx="3533948" cy="2072650"/>
          </a:xfrm>
          <a:prstGeom prst="roundRect">
            <a:avLst/>
          </a:prstGeom>
          <a:noFill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81042" tIns="90521" rIns="181042" bIns="90521" rtlCol="0" anchor="ctr"/>
          <a:lstStyle/>
          <a:p>
            <a:pPr algn="ctr"/>
            <a:endParaRPr lang="en-US"/>
          </a:p>
        </p:txBody>
      </p:sp>
      <p:sp>
        <p:nvSpPr>
          <p:cNvPr id="33" name="Rounded Rectangle 32"/>
          <p:cNvSpPr/>
          <p:nvPr/>
        </p:nvSpPr>
        <p:spPr>
          <a:xfrm>
            <a:off x="578113" y="6521451"/>
            <a:ext cx="3603754" cy="2039349"/>
          </a:xfrm>
          <a:prstGeom prst="roundRect">
            <a:avLst/>
          </a:prstGeom>
          <a:noFill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81042" tIns="90521" rIns="181042" bIns="90521" rtlCol="0" anchor="ctr"/>
          <a:lstStyle/>
          <a:p>
            <a:pPr algn="ctr"/>
            <a:endParaRPr lang="en-US"/>
          </a:p>
        </p:txBody>
      </p:sp>
      <p:sp>
        <p:nvSpPr>
          <p:cNvPr id="34" name="Rounded Rectangle 33"/>
          <p:cNvSpPr/>
          <p:nvPr/>
        </p:nvSpPr>
        <p:spPr>
          <a:xfrm>
            <a:off x="538470" y="4146696"/>
            <a:ext cx="3588771" cy="2039349"/>
          </a:xfrm>
          <a:prstGeom prst="roundRect">
            <a:avLst/>
          </a:prstGeom>
          <a:noFill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81042" tIns="90521" rIns="181042" bIns="90521" rtlCol="0" anchor="ctr"/>
          <a:lstStyle/>
          <a:p>
            <a:pPr algn="ctr"/>
            <a:endParaRPr lang="en-US"/>
          </a:p>
        </p:txBody>
      </p:sp>
      <p:graphicFrame>
        <p:nvGraphicFramePr>
          <p:cNvPr id="63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4022341"/>
              </p:ext>
            </p:extLst>
          </p:nvPr>
        </p:nvGraphicFramePr>
        <p:xfrm>
          <a:off x="6933523" y="994516"/>
          <a:ext cx="11792691" cy="630954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graphicFrame>
        <p:nvGraphicFramePr>
          <p:cNvPr id="67" name="Diagram 66"/>
          <p:cNvGraphicFramePr/>
          <p:nvPr>
            <p:extLst>
              <p:ext uri="{D42A27DB-BD31-4B8C-83A1-F6EECF244321}">
                <p14:modId xmlns:p14="http://schemas.microsoft.com/office/powerpoint/2010/main" val="1491449454"/>
              </p:ext>
            </p:extLst>
          </p:nvPr>
        </p:nvGraphicFramePr>
        <p:xfrm>
          <a:off x="7036009" y="5786120"/>
          <a:ext cx="11903014" cy="695828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8" r:lo="rId9" r:qs="rId10" r:cs="rId11"/>
          </a:graphicData>
        </a:graphic>
      </p:graphicFrame>
      <p:sp>
        <p:nvSpPr>
          <p:cNvPr id="74" name="TextBox 73"/>
          <p:cNvSpPr txBox="1"/>
          <p:nvPr/>
        </p:nvSpPr>
        <p:spPr>
          <a:xfrm>
            <a:off x="1069135" y="10854439"/>
            <a:ext cx="2497664" cy="552142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pPr algn="ctr"/>
            <a:r>
              <a:rPr lang="en-US" sz="2400" dirty="0"/>
              <a:t>16p11.2del (n=9)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888877" y="11388508"/>
            <a:ext cx="2830512" cy="1290805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pPr algn="ctr"/>
            <a:r>
              <a:rPr lang="en-US" sz="2400" i="1" dirty="0"/>
              <a:t>CHD8</a:t>
            </a:r>
            <a:r>
              <a:rPr lang="en-US" sz="2400" i="1" baseline="30000" dirty="0"/>
              <a:t>+/-</a:t>
            </a:r>
            <a:r>
              <a:rPr lang="en-US" sz="2400" dirty="0"/>
              <a:t> (n=9; 450K)</a:t>
            </a:r>
          </a:p>
          <a:p>
            <a:pPr algn="ctr"/>
            <a:r>
              <a:rPr lang="en-US" sz="2400" i="1" dirty="0"/>
              <a:t>CHD8</a:t>
            </a:r>
            <a:r>
              <a:rPr lang="en-US" sz="2400" i="1" baseline="30000" dirty="0"/>
              <a:t>+/-</a:t>
            </a:r>
            <a:r>
              <a:rPr lang="en-US" sz="2400" dirty="0"/>
              <a:t> (n=4; EPIC)</a:t>
            </a:r>
          </a:p>
          <a:p>
            <a:pPr algn="ctr"/>
            <a:endParaRPr lang="en-US" sz="2400" dirty="0"/>
          </a:p>
        </p:txBody>
      </p:sp>
      <p:sp>
        <p:nvSpPr>
          <p:cNvPr id="78" name="TextBox 77"/>
          <p:cNvSpPr txBox="1"/>
          <p:nvPr/>
        </p:nvSpPr>
        <p:spPr>
          <a:xfrm>
            <a:off x="3831263" y="10360758"/>
            <a:ext cx="2899817" cy="1044584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pPr algn="ctr"/>
            <a:r>
              <a:rPr lang="en-US" sz="2800" dirty="0"/>
              <a:t>Classify using </a:t>
            </a:r>
          </a:p>
          <a:p>
            <a:pPr algn="ctr"/>
            <a:r>
              <a:rPr lang="en-US" sz="2800" dirty="0" err="1"/>
              <a:t>DNAm</a:t>
            </a:r>
            <a:r>
              <a:rPr lang="en-US" sz="2800" dirty="0"/>
              <a:t> signatures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1781765" y="9328377"/>
            <a:ext cx="1266182" cy="736808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US" b="1" dirty="0" smtClean="0"/>
              <a:t>TEST</a:t>
            </a:r>
            <a:endParaRPr lang="en-US" b="1" dirty="0"/>
          </a:p>
        </p:txBody>
      </p:sp>
      <p:sp>
        <p:nvSpPr>
          <p:cNvPr id="82" name="Rectangle 81"/>
          <p:cNvSpPr/>
          <p:nvPr/>
        </p:nvSpPr>
        <p:spPr>
          <a:xfrm>
            <a:off x="496136" y="9946628"/>
            <a:ext cx="3611100" cy="921474"/>
          </a:xfrm>
          <a:prstGeom prst="rect">
            <a:avLst/>
          </a:prstGeom>
        </p:spPr>
        <p:txBody>
          <a:bodyPr wrap="none" lIns="181042" tIns="90521" rIns="181042" bIns="90521">
            <a:spAutoFit/>
          </a:bodyPr>
          <a:lstStyle/>
          <a:p>
            <a:pPr algn="ctr"/>
            <a:r>
              <a:rPr lang="en-US" sz="2400" u="sng" dirty="0"/>
              <a:t>Variant cases</a:t>
            </a:r>
          </a:p>
          <a:p>
            <a:pPr algn="ctr"/>
            <a:r>
              <a:rPr lang="en-US" sz="2400" dirty="0"/>
              <a:t>[pathogenic, benign, VUS]</a:t>
            </a:r>
          </a:p>
        </p:txBody>
      </p:sp>
      <p:cxnSp>
        <p:nvCxnSpPr>
          <p:cNvPr id="90" name="Straight Arrow Connector 89"/>
          <p:cNvCxnSpPr/>
          <p:nvPr/>
        </p:nvCxnSpPr>
        <p:spPr>
          <a:xfrm>
            <a:off x="2352872" y="2462208"/>
            <a:ext cx="0" cy="739139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/>
          <p:cNvCxnSpPr/>
          <p:nvPr/>
        </p:nvCxnSpPr>
        <p:spPr>
          <a:xfrm>
            <a:off x="2338573" y="7222241"/>
            <a:ext cx="0" cy="739139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9" name="Right Arrow Callout 98"/>
          <p:cNvSpPr/>
          <p:nvPr/>
        </p:nvSpPr>
        <p:spPr>
          <a:xfrm>
            <a:off x="277837" y="985144"/>
            <a:ext cx="6568314" cy="7722620"/>
          </a:xfrm>
          <a:prstGeom prst="rightArrowCallout">
            <a:avLst>
              <a:gd name="adj1" fmla="val 25000"/>
              <a:gd name="adj2" fmla="val 24577"/>
              <a:gd name="adj3" fmla="val 25000"/>
              <a:gd name="adj4" fmla="val 64977"/>
            </a:avLst>
          </a:prstGeom>
          <a:noFill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81042" tIns="90521" rIns="181042" bIns="90521" rtlCol="0" anchor="ctr"/>
          <a:lstStyle/>
          <a:p>
            <a:pPr algn="ctr"/>
            <a:endParaRPr lang="en-US"/>
          </a:p>
        </p:txBody>
      </p:sp>
      <p:sp>
        <p:nvSpPr>
          <p:cNvPr id="100" name="Right Arrow Callout 99"/>
          <p:cNvSpPr/>
          <p:nvPr/>
        </p:nvSpPr>
        <p:spPr>
          <a:xfrm>
            <a:off x="277838" y="9243938"/>
            <a:ext cx="6589698" cy="3281862"/>
          </a:xfrm>
          <a:prstGeom prst="rightArrowCallout">
            <a:avLst/>
          </a:prstGeom>
          <a:noFill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81042" tIns="90521" rIns="181042" bIns="90521" rtlCol="0" anchor="ctr"/>
          <a:lstStyle/>
          <a:p>
            <a:pPr algn="ctr"/>
            <a:endParaRPr lang="en-US"/>
          </a:p>
        </p:txBody>
      </p:sp>
      <p:sp>
        <p:nvSpPr>
          <p:cNvPr id="2" name="Left Brace 1"/>
          <p:cNvSpPr/>
          <p:nvPr/>
        </p:nvSpPr>
        <p:spPr>
          <a:xfrm>
            <a:off x="6825084" y="1332277"/>
            <a:ext cx="664667" cy="7027417"/>
          </a:xfrm>
          <a:prstGeom prst="lef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lIns="181042" tIns="90521" rIns="181042" bIns="90521" rtlCol="0" anchor="ctr"/>
          <a:lstStyle/>
          <a:p>
            <a:pPr algn="ctr"/>
            <a:endParaRPr lang="en-US"/>
          </a:p>
        </p:txBody>
      </p:sp>
      <p:sp>
        <p:nvSpPr>
          <p:cNvPr id="26" name="TextBox 25"/>
          <p:cNvSpPr txBox="1"/>
          <p:nvPr/>
        </p:nvSpPr>
        <p:spPr>
          <a:xfrm>
            <a:off x="0" y="13104441"/>
            <a:ext cx="4774715" cy="646331"/>
          </a:xfrm>
          <a:prstGeom prst="rect">
            <a:avLst/>
          </a:prstGeom>
          <a:noFill/>
        </p:spPr>
        <p:txBody>
          <a:bodyPr wrap="none" lIns="91384" tIns="45696" rIns="91384" bIns="45696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/>
              <a:t>1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1716490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9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7" dur="500"/>
                                        <p:tgtEl>
                                          <p:spTgt spid="6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9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0" dur="500"/>
                                        <p:tgtEl>
                                          <p:spTgt spid="6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Graphic spid="63" grpId="0">
        <p:bldAsOne/>
      </p:bldGraphic>
      <p:bldGraphic spid="67" grpId="0">
        <p:bldAsOne/>
      </p:bldGraphic>
    </p:bld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3104441"/>
            <a:ext cx="5008590" cy="646282"/>
          </a:xfrm>
          <a:prstGeom prst="rect">
            <a:avLst/>
          </a:prstGeom>
          <a:noFill/>
        </p:spPr>
        <p:txBody>
          <a:bodyPr wrap="none" lIns="91384" tIns="45696" rIns="91384" bIns="45696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10</a:t>
            </a:r>
            <a:r>
              <a:rPr lang="en-US" dirty="0" smtClean="0"/>
              <a:t>.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53247" y="3167336"/>
            <a:ext cx="12579011" cy="77086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58874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0" y="13104441"/>
            <a:ext cx="4774602" cy="646282"/>
          </a:xfrm>
          <a:prstGeom prst="rect">
            <a:avLst/>
          </a:prstGeom>
          <a:noFill/>
        </p:spPr>
        <p:txBody>
          <a:bodyPr wrap="none" lIns="91384" tIns="45696" rIns="91384" bIns="45696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/>
              <a:t>2</a:t>
            </a:r>
            <a:r>
              <a:rPr lang="en-US" dirty="0" smtClean="0"/>
              <a:t>.</a:t>
            </a:r>
            <a:endParaRPr lang="en-US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37223" y="1007096"/>
            <a:ext cx="12689880" cy="108888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45873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0" y="13104441"/>
            <a:ext cx="4774602" cy="646282"/>
          </a:xfrm>
          <a:prstGeom prst="rect">
            <a:avLst/>
          </a:prstGeom>
          <a:noFill/>
        </p:spPr>
        <p:txBody>
          <a:bodyPr wrap="none" lIns="91384" tIns="45696" rIns="91384" bIns="45696" rtlCol="0">
            <a:spAutoFit/>
          </a:bodyPr>
          <a:lstStyle/>
          <a:p>
            <a:r>
              <a:rPr lang="en-US" dirty="0" smtClean="0"/>
              <a:t>Supplementary Figure 3.</a:t>
            </a:r>
            <a:endParaRPr lang="en-US" dirty="0"/>
          </a:p>
        </p:txBody>
      </p:sp>
      <p:grpSp>
        <p:nvGrpSpPr>
          <p:cNvPr id="19" name="Group 18"/>
          <p:cNvGrpSpPr/>
          <p:nvPr/>
        </p:nvGrpSpPr>
        <p:grpSpPr>
          <a:xfrm>
            <a:off x="2953247" y="1440160"/>
            <a:ext cx="11808122" cy="10140499"/>
            <a:chOff x="2953247" y="1440160"/>
            <a:chExt cx="11808122" cy="10140499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53247" y="1440160"/>
              <a:ext cx="11808122" cy="10080104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6048401" y="11088216"/>
              <a:ext cx="7204328" cy="49244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2600" dirty="0" smtClean="0"/>
                <a:t>Change in </a:t>
              </a:r>
              <a:r>
                <a:rPr lang="en-US" sz="2600" dirty="0" err="1" smtClean="0"/>
                <a:t>ave</a:t>
              </a:r>
              <a:r>
                <a:rPr lang="en-US" sz="2600" dirty="0" smtClean="0"/>
                <a:t> </a:t>
              </a:r>
              <a:r>
                <a:rPr lang="en-US" sz="2600" dirty="0" err="1" smtClean="0"/>
                <a:t>DNAm</a:t>
              </a:r>
              <a:r>
                <a:rPr lang="en-US" sz="2600" dirty="0" smtClean="0"/>
                <a:t> between </a:t>
              </a:r>
              <a:r>
                <a:rPr lang="en-US" sz="2600" i="1" dirty="0" smtClean="0"/>
                <a:t>CHD8</a:t>
              </a:r>
              <a:r>
                <a:rPr lang="en-US" sz="2600" i="1" baseline="30000" dirty="0" smtClean="0"/>
                <a:t>+/-</a:t>
              </a:r>
              <a:r>
                <a:rPr lang="en-US" sz="2600" dirty="0" smtClean="0"/>
                <a:t> and Control</a:t>
              </a:r>
              <a:endParaRPr lang="en-US" sz="2600" dirty="0"/>
            </a:p>
          </p:txBody>
        </p:sp>
      </p:grpSp>
    </p:spTree>
    <p:extLst>
      <p:ext uri="{BB962C8B-B14F-4D97-AF65-F5344CB8AC3E}">
        <p14:creationId xmlns:p14="http://schemas.microsoft.com/office/powerpoint/2010/main" val="340457612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/>
        </p:nvGrpSpPr>
        <p:grpSpPr>
          <a:xfrm>
            <a:off x="216025" y="72017"/>
            <a:ext cx="8641880" cy="3329922"/>
            <a:chOff x="0" y="0"/>
            <a:chExt cx="9144000" cy="3329922"/>
          </a:xfrm>
        </p:grpSpPr>
        <p:pic>
          <p:nvPicPr>
            <p:cNvPr id="16" name="Picture 15" descr="Screen Shot 2017-05-21 at 11.25.02 PM.png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2587"/>
            <a:stretch/>
          </p:blipFill>
          <p:spPr>
            <a:xfrm>
              <a:off x="116522" y="2392217"/>
              <a:ext cx="8680828" cy="937705"/>
            </a:xfrm>
            <a:prstGeom prst="rect">
              <a:avLst/>
            </a:prstGeom>
          </p:spPr>
        </p:pic>
        <p:pic>
          <p:nvPicPr>
            <p:cNvPr id="17" name="Picture 16" descr="Screen Shot 2017-06-15 at 6.18.49 PM.png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0"/>
              <a:ext cx="9144000" cy="2271230"/>
            </a:xfrm>
            <a:prstGeom prst="rect">
              <a:avLst/>
            </a:prstGeom>
          </p:spPr>
        </p:pic>
      </p:grpSp>
      <p:grpSp>
        <p:nvGrpSpPr>
          <p:cNvPr id="25" name="Group 24"/>
          <p:cNvGrpSpPr/>
          <p:nvPr/>
        </p:nvGrpSpPr>
        <p:grpSpPr>
          <a:xfrm>
            <a:off x="9145934" y="72010"/>
            <a:ext cx="8800191" cy="3193452"/>
            <a:chOff x="919" y="3502275"/>
            <a:chExt cx="9144000" cy="3193453"/>
          </a:xfrm>
        </p:grpSpPr>
        <p:pic>
          <p:nvPicPr>
            <p:cNvPr id="20" name="Picture 19" descr="Screen Shot 2017-05-21 at 11.21.46 PM.png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6929"/>
            <a:stretch/>
          </p:blipFill>
          <p:spPr>
            <a:xfrm>
              <a:off x="104588" y="5887540"/>
              <a:ext cx="8652647" cy="808188"/>
            </a:xfrm>
            <a:prstGeom prst="rect">
              <a:avLst/>
            </a:prstGeom>
          </p:spPr>
        </p:pic>
        <p:pic>
          <p:nvPicPr>
            <p:cNvPr id="21" name="Picture 20" descr="Screen Shot 2017-06-15 at 6.21.15 PM.png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9" y="3502275"/>
              <a:ext cx="9144000" cy="2272862"/>
            </a:xfrm>
            <a:prstGeom prst="rect">
              <a:avLst/>
            </a:prstGeom>
          </p:spPr>
        </p:pic>
      </p:grpSp>
      <p:grpSp>
        <p:nvGrpSpPr>
          <p:cNvPr id="32" name="Group 31"/>
          <p:cNvGrpSpPr/>
          <p:nvPr/>
        </p:nvGrpSpPr>
        <p:grpSpPr>
          <a:xfrm>
            <a:off x="129719" y="6841784"/>
            <a:ext cx="8800191" cy="3220370"/>
            <a:chOff x="8857903" y="0"/>
            <a:chExt cx="9144000" cy="3220370"/>
          </a:xfrm>
        </p:grpSpPr>
        <p:pic>
          <p:nvPicPr>
            <p:cNvPr id="27" name="Picture 26" descr="Screen Shot 2017-05-21 at 11.34.56 PM.png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6559"/>
            <a:stretch/>
          </p:blipFill>
          <p:spPr>
            <a:xfrm>
              <a:off x="8961573" y="2403957"/>
              <a:ext cx="8695304" cy="816413"/>
            </a:xfrm>
            <a:prstGeom prst="rect">
              <a:avLst/>
            </a:prstGeom>
          </p:spPr>
        </p:pic>
        <p:pic>
          <p:nvPicPr>
            <p:cNvPr id="28" name="Picture 27" descr="Screen Shot 2017-06-15 at 6.30.39 PM.png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57903" y="0"/>
              <a:ext cx="9144000" cy="2276161"/>
            </a:xfrm>
            <a:prstGeom prst="rect">
              <a:avLst/>
            </a:prstGeom>
          </p:spPr>
        </p:pic>
      </p:grpSp>
      <p:grpSp>
        <p:nvGrpSpPr>
          <p:cNvPr id="31" name="Group 30"/>
          <p:cNvGrpSpPr/>
          <p:nvPr/>
        </p:nvGrpSpPr>
        <p:grpSpPr>
          <a:xfrm>
            <a:off x="9130722" y="6865869"/>
            <a:ext cx="8800191" cy="2947383"/>
            <a:chOff x="8843608" y="3527376"/>
            <a:chExt cx="9144000" cy="2947383"/>
          </a:xfrm>
        </p:grpSpPr>
        <p:pic>
          <p:nvPicPr>
            <p:cNvPr id="29" name="Picture 28" descr="Screen Shot 2017-05-21 at 11.37.58 PM.png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6085"/>
            <a:stretch/>
          </p:blipFill>
          <p:spPr>
            <a:xfrm>
              <a:off x="8934319" y="5939354"/>
              <a:ext cx="8695304" cy="535405"/>
            </a:xfrm>
            <a:prstGeom prst="rect">
              <a:avLst/>
            </a:prstGeom>
          </p:spPr>
        </p:pic>
        <p:pic>
          <p:nvPicPr>
            <p:cNvPr id="30" name="Picture 29" descr="Screen Shot 2017-06-15 at 6.31.35 PM.png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43608" y="3527376"/>
              <a:ext cx="9144000" cy="2274529"/>
            </a:xfrm>
            <a:prstGeom prst="rect">
              <a:avLst/>
            </a:prstGeom>
          </p:spPr>
        </p:pic>
      </p:grpSp>
      <p:sp>
        <p:nvSpPr>
          <p:cNvPr id="9" name="TextBox 8"/>
          <p:cNvSpPr txBox="1"/>
          <p:nvPr/>
        </p:nvSpPr>
        <p:spPr>
          <a:xfrm>
            <a:off x="793006" y="-1015"/>
            <a:ext cx="453857" cy="646282"/>
          </a:xfrm>
          <a:prstGeom prst="rect">
            <a:avLst/>
          </a:prstGeom>
          <a:noFill/>
        </p:spPr>
        <p:txBody>
          <a:bodyPr wrap="none" lIns="91384" tIns="45696" rIns="91384" bIns="45696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9758277" y="2"/>
            <a:ext cx="435786" cy="646331"/>
          </a:xfrm>
          <a:prstGeom prst="rect">
            <a:avLst/>
          </a:prstGeom>
          <a:noFill/>
        </p:spPr>
        <p:txBody>
          <a:bodyPr wrap="none" lIns="91384" tIns="45696" rIns="91384" bIns="45696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56358" y="6806233"/>
            <a:ext cx="436109" cy="645533"/>
          </a:xfrm>
          <a:prstGeom prst="rect">
            <a:avLst/>
          </a:prstGeom>
          <a:noFill/>
        </p:spPr>
        <p:txBody>
          <a:bodyPr wrap="none" lIns="91384" tIns="45696" rIns="91384" bIns="45696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9757358" y="6842503"/>
            <a:ext cx="468698" cy="646331"/>
          </a:xfrm>
          <a:prstGeom prst="rect">
            <a:avLst/>
          </a:prstGeom>
          <a:noFill/>
        </p:spPr>
        <p:txBody>
          <a:bodyPr wrap="none" lIns="91384" tIns="45696" rIns="91384" bIns="45696" rtlCol="0">
            <a:spAutoFit/>
          </a:bodyPr>
          <a:lstStyle/>
          <a:p>
            <a:r>
              <a:rPr lang="en-US" dirty="0"/>
              <a:t>D</a:t>
            </a: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145934" y="3137329"/>
            <a:ext cx="8984226" cy="3990455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88951" y="10081120"/>
            <a:ext cx="8554091" cy="3599385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9217944" y="10081121"/>
            <a:ext cx="8360926" cy="3527265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7" y="13260070"/>
            <a:ext cx="3499588" cy="492394"/>
          </a:xfrm>
          <a:prstGeom prst="rect">
            <a:avLst/>
          </a:prstGeom>
          <a:noFill/>
        </p:spPr>
        <p:txBody>
          <a:bodyPr wrap="none" lIns="91384" tIns="45696" rIns="91384" bIns="45696" rtlCol="0">
            <a:spAutoFit/>
          </a:bodyPr>
          <a:lstStyle/>
          <a:p>
            <a:r>
              <a:rPr lang="en-US" sz="2600" dirty="0"/>
              <a:t>Supplementary Figure </a:t>
            </a:r>
            <a:r>
              <a:rPr lang="en-US" sz="2600" dirty="0" smtClean="0"/>
              <a:t>4.</a:t>
            </a:r>
            <a:endParaRPr lang="en-US" sz="2600" dirty="0"/>
          </a:p>
        </p:txBody>
      </p:sp>
      <p:sp>
        <p:nvSpPr>
          <p:cNvPr id="2" name="Rectangle 1"/>
          <p:cNvSpPr/>
          <p:nvPr/>
        </p:nvSpPr>
        <p:spPr>
          <a:xfrm>
            <a:off x="0" y="0"/>
            <a:ext cx="18003838" cy="13679488"/>
          </a:xfrm>
          <a:prstGeom prst="rect">
            <a:avLst/>
          </a:prstGeom>
          <a:noFill/>
          <a:ln w="19050" cmpd="sng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91384" tIns="45696" rIns="91384" bIns="45696" rtlCol="0" anchor="ctr"/>
          <a:lstStyle/>
          <a:p>
            <a:pPr algn="ctr"/>
            <a:endParaRPr lang="en-US">
              <a:ln>
                <a:solidFill>
                  <a:srgbClr val="000000"/>
                </a:solidFill>
              </a:ln>
            </a:endParaRPr>
          </a:p>
        </p:txBody>
      </p:sp>
      <p:cxnSp>
        <p:nvCxnSpPr>
          <p:cNvPr id="4" name="Straight Connector 3"/>
          <p:cNvCxnSpPr/>
          <p:nvPr/>
        </p:nvCxnSpPr>
        <p:spPr>
          <a:xfrm>
            <a:off x="9001919" y="0"/>
            <a:ext cx="0" cy="13679488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0" y="6623721"/>
            <a:ext cx="18003838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" name="Picture 2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2648" y="3167336"/>
            <a:ext cx="8733253" cy="39187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38061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R:\Michelle\ASD+CHD8+16p\Oct_15 array\Blood cell type 16p+CHD8\Figures\For manuscript\Blood cell type PCA-@16p sig 19nov18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54" r="15561" b="13701"/>
          <a:stretch/>
        </p:blipFill>
        <p:spPr bwMode="auto">
          <a:xfrm>
            <a:off x="2438185" y="376276"/>
            <a:ext cx="10565468" cy="112555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3" name="Picture 3" descr="R:\Michelle\ASD+CHD8+16p\Oct_15 array\Blood cell type 16p+CHD8\Figures\For manuscript\Blood cell type PCA-@CHD8 sig.legend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25155" y="5461156"/>
            <a:ext cx="1537828" cy="40278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3276" y="13057866"/>
            <a:ext cx="4774602" cy="646282"/>
          </a:xfrm>
          <a:prstGeom prst="rect">
            <a:avLst/>
          </a:prstGeom>
          <a:noFill/>
        </p:spPr>
        <p:txBody>
          <a:bodyPr wrap="none" lIns="91384" tIns="45696" rIns="91384" bIns="45696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/>
              <a:t>5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695871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R:\Michelle\ASD+CHD8+16p\Oct_15 array\Blood cell type 16p+CHD8\Figures\For manuscript\Blood cell type PCA-@CHD8 sig 19nov18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66" t="15668" r="19310" b="17931"/>
          <a:stretch/>
        </p:blipFill>
        <p:spPr bwMode="auto">
          <a:xfrm>
            <a:off x="2361992" y="2361926"/>
            <a:ext cx="9600353" cy="86603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3" descr="R:\Michelle\ASD+CHD8+16p\Oct_15 array\Blood cell type 16p+CHD8\Figures\For manuscript\Blood cell type PCA-@CHD8 sig.legend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16988" y="4825821"/>
            <a:ext cx="1537828" cy="40278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0" y="13033206"/>
            <a:ext cx="4774602" cy="646282"/>
          </a:xfrm>
          <a:prstGeom prst="rect">
            <a:avLst/>
          </a:prstGeom>
          <a:noFill/>
        </p:spPr>
        <p:txBody>
          <a:bodyPr wrap="none" lIns="91384" tIns="45696" rIns="91384" bIns="45696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/>
              <a:t>6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179562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79460" y="-1016"/>
            <a:ext cx="15846392" cy="51330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79461" y="5130177"/>
            <a:ext cx="15851450" cy="41783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0270" y="9250574"/>
            <a:ext cx="15845583" cy="44319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2788352" y="468367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497243" y="2665714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8459482" y="2277674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4132136" y="1373020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805621" y="6112897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498767" y="7075468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206135" y="4920979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959683" y="6213672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6332808" y="7506366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7043224" y="7472702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4982806" y="7362733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5548395" y="6974693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4256141" y="6500938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4206135" y="9373590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998040" y="10522651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4982806" y="11858202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4982806" y="11870910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8602784" y="10666284"/>
            <a:ext cx="565589" cy="675306"/>
          </a:xfrm>
          <a:prstGeom prst="rect">
            <a:avLst/>
          </a:prstGeom>
          <a:noFill/>
        </p:spPr>
        <p:txBody>
          <a:bodyPr wrap="none" lIns="181042" tIns="90521" rIns="181042" bIns="90521" rtlCol="0">
            <a:spAutoFit/>
          </a:bodyPr>
          <a:lstStyle/>
          <a:p>
            <a:r>
              <a:rPr lang="en-CA" sz="3200" dirty="0"/>
              <a:t>*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148248" y="4414479"/>
            <a:ext cx="453971" cy="646331"/>
          </a:xfrm>
          <a:prstGeom prst="rect">
            <a:avLst/>
          </a:prstGeom>
          <a:noFill/>
        </p:spPr>
        <p:txBody>
          <a:bodyPr wrap="none" lIns="91384" tIns="45696" rIns="91384" bIns="45696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39" name="TextBox 38"/>
          <p:cNvSpPr txBox="1"/>
          <p:nvPr/>
        </p:nvSpPr>
        <p:spPr>
          <a:xfrm>
            <a:off x="2166108" y="8590942"/>
            <a:ext cx="435786" cy="646331"/>
          </a:xfrm>
          <a:prstGeom prst="rect">
            <a:avLst/>
          </a:prstGeom>
          <a:noFill/>
        </p:spPr>
        <p:txBody>
          <a:bodyPr wrap="none" lIns="91384" tIns="45696" rIns="91384" bIns="45696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2166110" y="12983430"/>
            <a:ext cx="436109" cy="645533"/>
          </a:xfrm>
          <a:prstGeom prst="rect">
            <a:avLst/>
          </a:prstGeom>
          <a:noFill/>
        </p:spPr>
        <p:txBody>
          <a:bodyPr wrap="none" lIns="91384" tIns="45696" rIns="91384" bIns="45696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41" name="TextBox 40"/>
          <p:cNvSpPr txBox="1"/>
          <p:nvPr/>
        </p:nvSpPr>
        <p:spPr>
          <a:xfrm>
            <a:off x="0" y="12849556"/>
            <a:ext cx="2089151" cy="830948"/>
          </a:xfrm>
          <a:prstGeom prst="rect">
            <a:avLst/>
          </a:prstGeom>
          <a:noFill/>
        </p:spPr>
        <p:txBody>
          <a:bodyPr wrap="square" lIns="91384" tIns="45696" rIns="91384" bIns="45696" rtlCol="0">
            <a:spAutoFit/>
          </a:bodyPr>
          <a:lstStyle/>
          <a:p>
            <a:r>
              <a:rPr lang="en-US" sz="2400" dirty="0" smtClean="0"/>
              <a:t>Supplementary Figure </a:t>
            </a:r>
            <a:r>
              <a:rPr lang="en-US" sz="2400" dirty="0"/>
              <a:t>7</a:t>
            </a:r>
            <a:r>
              <a:rPr lang="en-US" sz="2400" dirty="0" smtClean="0"/>
              <a:t>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2148920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13104441"/>
            <a:ext cx="4774602" cy="646282"/>
          </a:xfrm>
          <a:prstGeom prst="rect">
            <a:avLst/>
          </a:prstGeom>
          <a:noFill/>
        </p:spPr>
        <p:txBody>
          <a:bodyPr wrap="none" lIns="91384" tIns="45696" rIns="91384" bIns="45696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/>
              <a:t>8</a:t>
            </a:r>
            <a:r>
              <a:rPr lang="en-US" dirty="0" smtClean="0"/>
              <a:t>.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17343" y="3311352"/>
            <a:ext cx="10122933" cy="74359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880740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9231" y="3239344"/>
            <a:ext cx="12696514" cy="778068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13104441"/>
            <a:ext cx="4774602" cy="646282"/>
          </a:xfrm>
          <a:prstGeom prst="rect">
            <a:avLst/>
          </a:prstGeom>
          <a:noFill/>
        </p:spPr>
        <p:txBody>
          <a:bodyPr wrap="none" lIns="91384" tIns="45696" rIns="91384" bIns="45696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/>
              <a:t>9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4772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472</TotalTime>
  <Words>342</Words>
  <Application>Microsoft Macintosh PowerPoint</Application>
  <PresentationFormat>Custom</PresentationFormat>
  <Paragraphs>87</Paragraphs>
  <Slides>10</Slides>
  <Notes>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elle Siu</dc:creator>
  <cp:lastModifiedBy>M S</cp:lastModifiedBy>
  <cp:revision>195</cp:revision>
  <cp:lastPrinted>2019-03-14T20:02:27Z</cp:lastPrinted>
  <dcterms:created xsi:type="dcterms:W3CDTF">2016-12-16T20:50:19Z</dcterms:created>
  <dcterms:modified xsi:type="dcterms:W3CDTF">2019-03-14T20:33:49Z</dcterms:modified>
</cp:coreProperties>
</file>